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png" ContentType="image/png"/>
  <Override PartName="/ppt/media/image4.png" ContentType="image/png"/>
  <Override PartName="/ppt/media/image5.png" ContentType="image/png"/>
  <Override PartName="/ppt/media/image6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4344988" cy="5716588"/>
  <p:notesSz cx="6858000" cy="90789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2FBC90-35F4-4D2B-B25C-AFFD5B984A8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220680" y="228600"/>
            <a:ext cx="3905280" cy="95256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ctr">
            <a:noAutofit/>
          </a:bodyPr>
          <a:p>
            <a:pPr indent="0" algn="ctr">
              <a:buNone/>
              <a:tabLst>
                <a:tab algn="l" pos="0"/>
                <a:tab algn="l" pos="525600"/>
                <a:tab algn="l" pos="1050840"/>
                <a:tab algn="l" pos="1576440"/>
                <a:tab algn="l" pos="2101680"/>
                <a:tab algn="l" pos="2627280"/>
                <a:tab algn="l" pos="3152880"/>
                <a:tab algn="l" pos="3678120"/>
                <a:tab algn="l" pos="4203720"/>
                <a:tab algn="l" pos="4729320"/>
                <a:tab algn="l" pos="5254560"/>
                <a:tab algn="l" pos="5780160"/>
                <a:tab algn="l" pos="6305400"/>
                <a:tab algn="l" pos="6831000"/>
                <a:tab algn="l" pos="7356600"/>
                <a:tab algn="l" pos="7881840"/>
                <a:tab algn="l" pos="8407440"/>
                <a:tab algn="l" pos="8933040"/>
                <a:tab algn="l" pos="9458280"/>
                <a:tab algn="l" pos="9983880"/>
                <a:tab algn="l" pos="1050912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220680" y="1331640"/>
            <a:ext cx="3905280" cy="179820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5600"/>
                <a:tab algn="l" pos="1050840"/>
                <a:tab algn="l" pos="1576440"/>
                <a:tab algn="l" pos="2101680"/>
                <a:tab algn="l" pos="2627280"/>
                <a:tab algn="l" pos="3152880"/>
                <a:tab algn="l" pos="3678120"/>
                <a:tab algn="l" pos="4203720"/>
                <a:tab algn="l" pos="4729320"/>
                <a:tab algn="l" pos="5254560"/>
                <a:tab algn="l" pos="5780160"/>
                <a:tab algn="l" pos="6305400"/>
                <a:tab algn="l" pos="6831000"/>
                <a:tab algn="l" pos="7356600"/>
                <a:tab algn="l" pos="7881840"/>
                <a:tab algn="l" pos="8407440"/>
                <a:tab algn="l" pos="8933040"/>
                <a:tab algn="l" pos="9458280"/>
                <a:tab algn="l" pos="9983880"/>
                <a:tab algn="l" pos="1050912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220680" y="3301200"/>
            <a:ext cx="3905280" cy="179820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5600"/>
                <a:tab algn="l" pos="1050840"/>
                <a:tab algn="l" pos="1576440"/>
                <a:tab algn="l" pos="2101680"/>
                <a:tab algn="l" pos="2627280"/>
                <a:tab algn="l" pos="3152880"/>
                <a:tab algn="l" pos="3678120"/>
                <a:tab algn="l" pos="4203720"/>
                <a:tab algn="l" pos="4729320"/>
                <a:tab algn="l" pos="5254560"/>
                <a:tab algn="l" pos="5780160"/>
                <a:tab algn="l" pos="6305400"/>
                <a:tab algn="l" pos="6831000"/>
                <a:tab algn="l" pos="7356600"/>
                <a:tab algn="l" pos="7881840"/>
                <a:tab algn="l" pos="8407440"/>
                <a:tab algn="l" pos="8933040"/>
                <a:tab algn="l" pos="9458280"/>
                <a:tab algn="l" pos="9983880"/>
                <a:tab algn="l" pos="1050912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5FC8FD-CAEE-4595-A6E7-CF69BA9DDD5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220680" y="228600"/>
            <a:ext cx="3905280" cy="95256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ctr">
            <a:noAutofit/>
          </a:bodyPr>
          <a:p>
            <a:pPr indent="0" algn="ctr">
              <a:buNone/>
              <a:tabLst>
                <a:tab algn="l" pos="0"/>
                <a:tab algn="l" pos="525600"/>
                <a:tab algn="l" pos="1050840"/>
                <a:tab algn="l" pos="1576440"/>
                <a:tab algn="l" pos="2101680"/>
                <a:tab algn="l" pos="2627280"/>
                <a:tab algn="l" pos="3152880"/>
                <a:tab algn="l" pos="3678120"/>
                <a:tab algn="l" pos="4203720"/>
                <a:tab algn="l" pos="4729320"/>
                <a:tab algn="l" pos="5254560"/>
                <a:tab algn="l" pos="5780160"/>
                <a:tab algn="l" pos="6305400"/>
                <a:tab algn="l" pos="6831000"/>
                <a:tab algn="l" pos="7356600"/>
                <a:tab algn="l" pos="7881840"/>
                <a:tab algn="l" pos="8407440"/>
                <a:tab algn="l" pos="8933040"/>
                <a:tab algn="l" pos="9458280"/>
                <a:tab algn="l" pos="9983880"/>
                <a:tab algn="l" pos="1050912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220680" y="1331640"/>
            <a:ext cx="1905480" cy="179820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5600"/>
                <a:tab algn="l" pos="1050840"/>
                <a:tab algn="l" pos="1576440"/>
                <a:tab algn="l" pos="2101680"/>
                <a:tab algn="l" pos="2627280"/>
                <a:tab algn="l" pos="3152880"/>
                <a:tab algn="l" pos="3678120"/>
                <a:tab algn="l" pos="4203720"/>
                <a:tab algn="l" pos="4729320"/>
                <a:tab algn="l" pos="5254560"/>
                <a:tab algn="l" pos="5780160"/>
                <a:tab algn="l" pos="6305400"/>
                <a:tab algn="l" pos="6831000"/>
                <a:tab algn="l" pos="7356600"/>
                <a:tab algn="l" pos="7881840"/>
                <a:tab algn="l" pos="8407440"/>
                <a:tab algn="l" pos="8933040"/>
                <a:tab algn="l" pos="9458280"/>
                <a:tab algn="l" pos="9983880"/>
                <a:tab algn="l" pos="1050912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2221920" y="1331640"/>
            <a:ext cx="1905480" cy="179820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5600"/>
                <a:tab algn="l" pos="1050840"/>
                <a:tab algn="l" pos="1576440"/>
                <a:tab algn="l" pos="2101680"/>
                <a:tab algn="l" pos="2627280"/>
                <a:tab algn="l" pos="3152880"/>
                <a:tab algn="l" pos="3678120"/>
                <a:tab algn="l" pos="4203720"/>
                <a:tab algn="l" pos="4729320"/>
                <a:tab algn="l" pos="5254560"/>
                <a:tab algn="l" pos="5780160"/>
                <a:tab algn="l" pos="6305400"/>
                <a:tab algn="l" pos="6831000"/>
                <a:tab algn="l" pos="7356600"/>
                <a:tab algn="l" pos="7881840"/>
                <a:tab algn="l" pos="8407440"/>
                <a:tab algn="l" pos="8933040"/>
                <a:tab algn="l" pos="9458280"/>
                <a:tab algn="l" pos="9983880"/>
                <a:tab algn="l" pos="1050912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220680" y="3301200"/>
            <a:ext cx="1905480" cy="179820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5600"/>
                <a:tab algn="l" pos="1050840"/>
                <a:tab algn="l" pos="1576440"/>
                <a:tab algn="l" pos="2101680"/>
                <a:tab algn="l" pos="2627280"/>
                <a:tab algn="l" pos="3152880"/>
                <a:tab algn="l" pos="3678120"/>
                <a:tab algn="l" pos="4203720"/>
                <a:tab algn="l" pos="4729320"/>
                <a:tab algn="l" pos="5254560"/>
                <a:tab algn="l" pos="5780160"/>
                <a:tab algn="l" pos="6305400"/>
                <a:tab algn="l" pos="6831000"/>
                <a:tab algn="l" pos="7356600"/>
                <a:tab algn="l" pos="7881840"/>
                <a:tab algn="l" pos="8407440"/>
                <a:tab algn="l" pos="8933040"/>
                <a:tab algn="l" pos="9458280"/>
                <a:tab algn="l" pos="9983880"/>
                <a:tab algn="l" pos="1050912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2221920" y="3301200"/>
            <a:ext cx="1905480" cy="179820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5600"/>
                <a:tab algn="l" pos="1050840"/>
                <a:tab algn="l" pos="1576440"/>
                <a:tab algn="l" pos="2101680"/>
                <a:tab algn="l" pos="2627280"/>
                <a:tab algn="l" pos="3152880"/>
                <a:tab algn="l" pos="3678120"/>
                <a:tab algn="l" pos="4203720"/>
                <a:tab algn="l" pos="4729320"/>
                <a:tab algn="l" pos="5254560"/>
                <a:tab algn="l" pos="5780160"/>
                <a:tab algn="l" pos="6305400"/>
                <a:tab algn="l" pos="6831000"/>
                <a:tab algn="l" pos="7356600"/>
                <a:tab algn="l" pos="7881840"/>
                <a:tab algn="l" pos="8407440"/>
                <a:tab algn="l" pos="8933040"/>
                <a:tab algn="l" pos="9458280"/>
                <a:tab algn="l" pos="9983880"/>
                <a:tab algn="l" pos="1050912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9DA6A2-F221-46DD-8D29-D815AF7A02B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220680" y="228600"/>
            <a:ext cx="3905280" cy="95256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ctr">
            <a:noAutofit/>
          </a:bodyPr>
          <a:p>
            <a:pPr indent="0" algn="ctr">
              <a:buNone/>
              <a:tabLst>
                <a:tab algn="l" pos="0"/>
                <a:tab algn="l" pos="525600"/>
                <a:tab algn="l" pos="1050840"/>
                <a:tab algn="l" pos="1576440"/>
                <a:tab algn="l" pos="2101680"/>
                <a:tab algn="l" pos="2627280"/>
                <a:tab algn="l" pos="3152880"/>
                <a:tab algn="l" pos="3678120"/>
                <a:tab algn="l" pos="4203720"/>
                <a:tab algn="l" pos="4729320"/>
                <a:tab algn="l" pos="5254560"/>
                <a:tab algn="l" pos="5780160"/>
                <a:tab algn="l" pos="6305400"/>
                <a:tab algn="l" pos="6831000"/>
                <a:tab algn="l" pos="7356600"/>
                <a:tab algn="l" pos="7881840"/>
                <a:tab algn="l" pos="8407440"/>
                <a:tab algn="l" pos="8933040"/>
                <a:tab algn="l" pos="9458280"/>
                <a:tab algn="l" pos="9983880"/>
                <a:tab algn="l" pos="1050912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220680" y="1331640"/>
            <a:ext cx="1257120" cy="179820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5600"/>
                <a:tab algn="l" pos="1050840"/>
                <a:tab algn="l" pos="1576440"/>
                <a:tab algn="l" pos="2101680"/>
                <a:tab algn="l" pos="2627280"/>
                <a:tab algn="l" pos="3152880"/>
                <a:tab algn="l" pos="3678120"/>
                <a:tab algn="l" pos="4203720"/>
                <a:tab algn="l" pos="4729320"/>
                <a:tab algn="l" pos="5254560"/>
                <a:tab algn="l" pos="5780160"/>
                <a:tab algn="l" pos="6305400"/>
                <a:tab algn="l" pos="6831000"/>
                <a:tab algn="l" pos="7356600"/>
                <a:tab algn="l" pos="7881840"/>
                <a:tab algn="l" pos="8407440"/>
                <a:tab algn="l" pos="8933040"/>
                <a:tab algn="l" pos="9458280"/>
                <a:tab algn="l" pos="9983880"/>
                <a:tab algn="l" pos="1050912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1541160" y="1331640"/>
            <a:ext cx="1257120" cy="179820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5600"/>
                <a:tab algn="l" pos="1050840"/>
                <a:tab algn="l" pos="1576440"/>
                <a:tab algn="l" pos="2101680"/>
                <a:tab algn="l" pos="2627280"/>
                <a:tab algn="l" pos="3152880"/>
                <a:tab algn="l" pos="3678120"/>
                <a:tab algn="l" pos="4203720"/>
                <a:tab algn="l" pos="4729320"/>
                <a:tab algn="l" pos="5254560"/>
                <a:tab algn="l" pos="5780160"/>
                <a:tab algn="l" pos="6305400"/>
                <a:tab algn="l" pos="6831000"/>
                <a:tab algn="l" pos="7356600"/>
                <a:tab algn="l" pos="7881840"/>
                <a:tab algn="l" pos="8407440"/>
                <a:tab algn="l" pos="8933040"/>
                <a:tab algn="l" pos="9458280"/>
                <a:tab algn="l" pos="9983880"/>
                <a:tab algn="l" pos="1050912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2861280" y="1331640"/>
            <a:ext cx="1257120" cy="179820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5600"/>
                <a:tab algn="l" pos="1050840"/>
                <a:tab algn="l" pos="1576440"/>
                <a:tab algn="l" pos="2101680"/>
                <a:tab algn="l" pos="2627280"/>
                <a:tab algn="l" pos="3152880"/>
                <a:tab algn="l" pos="3678120"/>
                <a:tab algn="l" pos="4203720"/>
                <a:tab algn="l" pos="4729320"/>
                <a:tab algn="l" pos="5254560"/>
                <a:tab algn="l" pos="5780160"/>
                <a:tab algn="l" pos="6305400"/>
                <a:tab algn="l" pos="6831000"/>
                <a:tab algn="l" pos="7356600"/>
                <a:tab algn="l" pos="7881840"/>
                <a:tab algn="l" pos="8407440"/>
                <a:tab algn="l" pos="8933040"/>
                <a:tab algn="l" pos="9458280"/>
                <a:tab algn="l" pos="9983880"/>
                <a:tab algn="l" pos="1050912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220680" y="3301200"/>
            <a:ext cx="1257120" cy="179820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5600"/>
                <a:tab algn="l" pos="1050840"/>
                <a:tab algn="l" pos="1576440"/>
                <a:tab algn="l" pos="2101680"/>
                <a:tab algn="l" pos="2627280"/>
                <a:tab algn="l" pos="3152880"/>
                <a:tab algn="l" pos="3678120"/>
                <a:tab algn="l" pos="4203720"/>
                <a:tab algn="l" pos="4729320"/>
                <a:tab algn="l" pos="5254560"/>
                <a:tab algn="l" pos="5780160"/>
                <a:tab algn="l" pos="6305400"/>
                <a:tab algn="l" pos="6831000"/>
                <a:tab algn="l" pos="7356600"/>
                <a:tab algn="l" pos="7881840"/>
                <a:tab algn="l" pos="8407440"/>
                <a:tab algn="l" pos="8933040"/>
                <a:tab algn="l" pos="9458280"/>
                <a:tab algn="l" pos="9983880"/>
                <a:tab algn="l" pos="1050912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1541160" y="3301200"/>
            <a:ext cx="1257120" cy="179820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5600"/>
                <a:tab algn="l" pos="1050840"/>
                <a:tab algn="l" pos="1576440"/>
                <a:tab algn="l" pos="2101680"/>
                <a:tab algn="l" pos="2627280"/>
                <a:tab algn="l" pos="3152880"/>
                <a:tab algn="l" pos="3678120"/>
                <a:tab algn="l" pos="4203720"/>
                <a:tab algn="l" pos="4729320"/>
                <a:tab algn="l" pos="5254560"/>
                <a:tab algn="l" pos="5780160"/>
                <a:tab algn="l" pos="6305400"/>
                <a:tab algn="l" pos="6831000"/>
                <a:tab algn="l" pos="7356600"/>
                <a:tab algn="l" pos="7881840"/>
                <a:tab algn="l" pos="8407440"/>
                <a:tab algn="l" pos="8933040"/>
                <a:tab algn="l" pos="9458280"/>
                <a:tab algn="l" pos="9983880"/>
                <a:tab algn="l" pos="1050912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2861280" y="3301200"/>
            <a:ext cx="1257120" cy="179820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5600"/>
                <a:tab algn="l" pos="1050840"/>
                <a:tab algn="l" pos="1576440"/>
                <a:tab algn="l" pos="2101680"/>
                <a:tab algn="l" pos="2627280"/>
                <a:tab algn="l" pos="3152880"/>
                <a:tab algn="l" pos="3678120"/>
                <a:tab algn="l" pos="4203720"/>
                <a:tab algn="l" pos="4729320"/>
                <a:tab algn="l" pos="5254560"/>
                <a:tab algn="l" pos="5780160"/>
                <a:tab algn="l" pos="6305400"/>
                <a:tab algn="l" pos="6831000"/>
                <a:tab algn="l" pos="7356600"/>
                <a:tab algn="l" pos="7881840"/>
                <a:tab algn="l" pos="8407440"/>
                <a:tab algn="l" pos="8933040"/>
                <a:tab algn="l" pos="9458280"/>
                <a:tab algn="l" pos="9983880"/>
                <a:tab algn="l" pos="1050912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75E739-908E-4C79-B5BE-91FEE9548EB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220680" y="228600"/>
            <a:ext cx="3905280" cy="95256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ctr">
            <a:noAutofit/>
          </a:bodyPr>
          <a:p>
            <a:pPr indent="0" algn="ctr">
              <a:buNone/>
              <a:tabLst>
                <a:tab algn="l" pos="0"/>
                <a:tab algn="l" pos="525600"/>
                <a:tab algn="l" pos="1050840"/>
                <a:tab algn="l" pos="1576440"/>
                <a:tab algn="l" pos="2101680"/>
                <a:tab algn="l" pos="2627280"/>
                <a:tab algn="l" pos="3152880"/>
                <a:tab algn="l" pos="3678120"/>
                <a:tab algn="l" pos="4203720"/>
                <a:tab algn="l" pos="4729320"/>
                <a:tab algn="l" pos="5254560"/>
                <a:tab algn="l" pos="5780160"/>
                <a:tab algn="l" pos="6305400"/>
                <a:tab algn="l" pos="6831000"/>
                <a:tab algn="l" pos="7356600"/>
                <a:tab algn="l" pos="7881840"/>
                <a:tab algn="l" pos="8407440"/>
                <a:tab algn="l" pos="8933040"/>
                <a:tab algn="l" pos="9458280"/>
                <a:tab algn="l" pos="9983880"/>
                <a:tab algn="l" pos="1050912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220680" y="1331640"/>
            <a:ext cx="3905280" cy="3770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451"/>
              </a:spcBef>
              <a:buNone/>
              <a:tabLst>
                <a:tab algn="l" pos="0"/>
                <a:tab algn="l" pos="525600"/>
                <a:tab algn="l" pos="1050840"/>
                <a:tab algn="l" pos="1576440"/>
                <a:tab algn="l" pos="2101680"/>
                <a:tab algn="l" pos="2627280"/>
                <a:tab algn="l" pos="3152880"/>
                <a:tab algn="l" pos="3678120"/>
                <a:tab algn="l" pos="4203720"/>
                <a:tab algn="l" pos="4729320"/>
                <a:tab algn="l" pos="5254560"/>
                <a:tab algn="l" pos="5780160"/>
                <a:tab algn="l" pos="6305400"/>
                <a:tab algn="l" pos="6831000"/>
                <a:tab algn="l" pos="7356600"/>
                <a:tab algn="l" pos="7881840"/>
                <a:tab algn="l" pos="8407440"/>
                <a:tab algn="l" pos="8933040"/>
                <a:tab algn="l" pos="9458280"/>
                <a:tab algn="l" pos="9983880"/>
                <a:tab algn="l" pos="1050912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C87A67-36D1-4C34-A0B1-68B6788C615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220680" y="228600"/>
            <a:ext cx="3905280" cy="95256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ctr">
            <a:noAutofit/>
          </a:bodyPr>
          <a:p>
            <a:pPr indent="0" algn="ctr">
              <a:buNone/>
              <a:tabLst>
                <a:tab algn="l" pos="0"/>
                <a:tab algn="l" pos="525600"/>
                <a:tab algn="l" pos="1050840"/>
                <a:tab algn="l" pos="1576440"/>
                <a:tab algn="l" pos="2101680"/>
                <a:tab algn="l" pos="2627280"/>
                <a:tab algn="l" pos="3152880"/>
                <a:tab algn="l" pos="3678120"/>
                <a:tab algn="l" pos="4203720"/>
                <a:tab algn="l" pos="4729320"/>
                <a:tab algn="l" pos="5254560"/>
                <a:tab algn="l" pos="5780160"/>
                <a:tab algn="l" pos="6305400"/>
                <a:tab algn="l" pos="6831000"/>
                <a:tab algn="l" pos="7356600"/>
                <a:tab algn="l" pos="7881840"/>
                <a:tab algn="l" pos="8407440"/>
                <a:tab algn="l" pos="8933040"/>
                <a:tab algn="l" pos="9458280"/>
                <a:tab algn="l" pos="9983880"/>
                <a:tab algn="l" pos="1050912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220680" y="1331640"/>
            <a:ext cx="3905280" cy="377028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5600"/>
                <a:tab algn="l" pos="1050840"/>
                <a:tab algn="l" pos="1576440"/>
                <a:tab algn="l" pos="2101680"/>
                <a:tab algn="l" pos="2627280"/>
                <a:tab algn="l" pos="3152880"/>
                <a:tab algn="l" pos="3678120"/>
                <a:tab algn="l" pos="4203720"/>
                <a:tab algn="l" pos="4729320"/>
                <a:tab algn="l" pos="5254560"/>
                <a:tab algn="l" pos="5780160"/>
                <a:tab algn="l" pos="6305400"/>
                <a:tab algn="l" pos="6831000"/>
                <a:tab algn="l" pos="7356600"/>
                <a:tab algn="l" pos="7881840"/>
                <a:tab algn="l" pos="8407440"/>
                <a:tab algn="l" pos="8933040"/>
                <a:tab algn="l" pos="9458280"/>
                <a:tab algn="l" pos="9983880"/>
                <a:tab algn="l" pos="1050912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986ACD-5EE4-42FA-A0B2-75FF793FEDF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220680" y="228600"/>
            <a:ext cx="3905280" cy="95256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ctr">
            <a:noAutofit/>
          </a:bodyPr>
          <a:p>
            <a:pPr indent="0" algn="ctr">
              <a:buNone/>
              <a:tabLst>
                <a:tab algn="l" pos="0"/>
                <a:tab algn="l" pos="525600"/>
                <a:tab algn="l" pos="1050840"/>
                <a:tab algn="l" pos="1576440"/>
                <a:tab algn="l" pos="2101680"/>
                <a:tab algn="l" pos="2627280"/>
                <a:tab algn="l" pos="3152880"/>
                <a:tab algn="l" pos="3678120"/>
                <a:tab algn="l" pos="4203720"/>
                <a:tab algn="l" pos="4729320"/>
                <a:tab algn="l" pos="5254560"/>
                <a:tab algn="l" pos="5780160"/>
                <a:tab algn="l" pos="6305400"/>
                <a:tab algn="l" pos="6831000"/>
                <a:tab algn="l" pos="7356600"/>
                <a:tab algn="l" pos="7881840"/>
                <a:tab algn="l" pos="8407440"/>
                <a:tab algn="l" pos="8933040"/>
                <a:tab algn="l" pos="9458280"/>
                <a:tab algn="l" pos="9983880"/>
                <a:tab algn="l" pos="1050912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220680" y="1331640"/>
            <a:ext cx="1905480" cy="377028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5600"/>
                <a:tab algn="l" pos="1050840"/>
                <a:tab algn="l" pos="1576440"/>
                <a:tab algn="l" pos="2101680"/>
                <a:tab algn="l" pos="2627280"/>
                <a:tab algn="l" pos="3152880"/>
                <a:tab algn="l" pos="3678120"/>
                <a:tab algn="l" pos="4203720"/>
                <a:tab algn="l" pos="4729320"/>
                <a:tab algn="l" pos="5254560"/>
                <a:tab algn="l" pos="5780160"/>
                <a:tab algn="l" pos="6305400"/>
                <a:tab algn="l" pos="6831000"/>
                <a:tab algn="l" pos="7356600"/>
                <a:tab algn="l" pos="7881840"/>
                <a:tab algn="l" pos="8407440"/>
                <a:tab algn="l" pos="8933040"/>
                <a:tab algn="l" pos="9458280"/>
                <a:tab algn="l" pos="9983880"/>
                <a:tab algn="l" pos="1050912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2221920" y="1331640"/>
            <a:ext cx="1905480" cy="377028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5600"/>
                <a:tab algn="l" pos="1050840"/>
                <a:tab algn="l" pos="1576440"/>
                <a:tab algn="l" pos="2101680"/>
                <a:tab algn="l" pos="2627280"/>
                <a:tab algn="l" pos="3152880"/>
                <a:tab algn="l" pos="3678120"/>
                <a:tab algn="l" pos="4203720"/>
                <a:tab algn="l" pos="4729320"/>
                <a:tab algn="l" pos="5254560"/>
                <a:tab algn="l" pos="5780160"/>
                <a:tab algn="l" pos="6305400"/>
                <a:tab algn="l" pos="6831000"/>
                <a:tab algn="l" pos="7356600"/>
                <a:tab algn="l" pos="7881840"/>
                <a:tab algn="l" pos="8407440"/>
                <a:tab algn="l" pos="8933040"/>
                <a:tab algn="l" pos="9458280"/>
                <a:tab algn="l" pos="9983880"/>
                <a:tab algn="l" pos="1050912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06F448-D940-4CAA-8F60-BEFF412394A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220680" y="228600"/>
            <a:ext cx="3905280" cy="95256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ctr">
            <a:noAutofit/>
          </a:bodyPr>
          <a:p>
            <a:pPr indent="0" algn="ctr">
              <a:buNone/>
              <a:tabLst>
                <a:tab algn="l" pos="0"/>
                <a:tab algn="l" pos="525600"/>
                <a:tab algn="l" pos="1050840"/>
                <a:tab algn="l" pos="1576440"/>
                <a:tab algn="l" pos="2101680"/>
                <a:tab algn="l" pos="2627280"/>
                <a:tab algn="l" pos="3152880"/>
                <a:tab algn="l" pos="3678120"/>
                <a:tab algn="l" pos="4203720"/>
                <a:tab algn="l" pos="4729320"/>
                <a:tab algn="l" pos="5254560"/>
                <a:tab algn="l" pos="5780160"/>
                <a:tab algn="l" pos="6305400"/>
                <a:tab algn="l" pos="6831000"/>
                <a:tab algn="l" pos="7356600"/>
                <a:tab algn="l" pos="7881840"/>
                <a:tab algn="l" pos="8407440"/>
                <a:tab algn="l" pos="8933040"/>
                <a:tab algn="l" pos="9458280"/>
                <a:tab algn="l" pos="9983880"/>
                <a:tab algn="l" pos="1050912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387B51-0306-4F10-AAA2-7FDACD5D084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220680" y="228600"/>
            <a:ext cx="3905280" cy="441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451"/>
              </a:spcBef>
              <a:tabLst>
                <a:tab algn="l" pos="0"/>
                <a:tab algn="l" pos="525600"/>
                <a:tab algn="l" pos="1050840"/>
                <a:tab algn="l" pos="1576440"/>
                <a:tab algn="l" pos="2101680"/>
                <a:tab algn="l" pos="2627280"/>
                <a:tab algn="l" pos="3152880"/>
                <a:tab algn="l" pos="3678120"/>
                <a:tab algn="l" pos="4203720"/>
                <a:tab algn="l" pos="4729320"/>
                <a:tab algn="l" pos="5254560"/>
                <a:tab algn="l" pos="5780160"/>
                <a:tab algn="l" pos="6305400"/>
                <a:tab algn="l" pos="6831000"/>
                <a:tab algn="l" pos="7356600"/>
                <a:tab algn="l" pos="7881840"/>
                <a:tab algn="l" pos="8407440"/>
                <a:tab algn="l" pos="8933040"/>
                <a:tab algn="l" pos="9458280"/>
                <a:tab algn="l" pos="9983880"/>
                <a:tab algn="l" pos="1050912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373C81-3B89-402B-A93C-E12CB122760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220680" y="228600"/>
            <a:ext cx="3905280" cy="95256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ctr">
            <a:noAutofit/>
          </a:bodyPr>
          <a:p>
            <a:pPr indent="0" algn="ctr">
              <a:buNone/>
              <a:tabLst>
                <a:tab algn="l" pos="0"/>
                <a:tab algn="l" pos="525600"/>
                <a:tab algn="l" pos="1050840"/>
                <a:tab algn="l" pos="1576440"/>
                <a:tab algn="l" pos="2101680"/>
                <a:tab algn="l" pos="2627280"/>
                <a:tab algn="l" pos="3152880"/>
                <a:tab algn="l" pos="3678120"/>
                <a:tab algn="l" pos="4203720"/>
                <a:tab algn="l" pos="4729320"/>
                <a:tab algn="l" pos="5254560"/>
                <a:tab algn="l" pos="5780160"/>
                <a:tab algn="l" pos="6305400"/>
                <a:tab algn="l" pos="6831000"/>
                <a:tab algn="l" pos="7356600"/>
                <a:tab algn="l" pos="7881840"/>
                <a:tab algn="l" pos="8407440"/>
                <a:tab algn="l" pos="8933040"/>
                <a:tab algn="l" pos="9458280"/>
                <a:tab algn="l" pos="9983880"/>
                <a:tab algn="l" pos="1050912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220680" y="1331640"/>
            <a:ext cx="1905480" cy="179820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5600"/>
                <a:tab algn="l" pos="1050840"/>
                <a:tab algn="l" pos="1576440"/>
                <a:tab algn="l" pos="2101680"/>
                <a:tab algn="l" pos="2627280"/>
                <a:tab algn="l" pos="3152880"/>
                <a:tab algn="l" pos="3678120"/>
                <a:tab algn="l" pos="4203720"/>
                <a:tab algn="l" pos="4729320"/>
                <a:tab algn="l" pos="5254560"/>
                <a:tab algn="l" pos="5780160"/>
                <a:tab algn="l" pos="6305400"/>
                <a:tab algn="l" pos="6831000"/>
                <a:tab algn="l" pos="7356600"/>
                <a:tab algn="l" pos="7881840"/>
                <a:tab algn="l" pos="8407440"/>
                <a:tab algn="l" pos="8933040"/>
                <a:tab algn="l" pos="9458280"/>
                <a:tab algn="l" pos="9983880"/>
                <a:tab algn="l" pos="1050912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2221920" y="1331640"/>
            <a:ext cx="1905480" cy="377028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5600"/>
                <a:tab algn="l" pos="1050840"/>
                <a:tab algn="l" pos="1576440"/>
                <a:tab algn="l" pos="2101680"/>
                <a:tab algn="l" pos="2627280"/>
                <a:tab algn="l" pos="3152880"/>
                <a:tab algn="l" pos="3678120"/>
                <a:tab algn="l" pos="4203720"/>
                <a:tab algn="l" pos="4729320"/>
                <a:tab algn="l" pos="5254560"/>
                <a:tab algn="l" pos="5780160"/>
                <a:tab algn="l" pos="6305400"/>
                <a:tab algn="l" pos="6831000"/>
                <a:tab algn="l" pos="7356600"/>
                <a:tab algn="l" pos="7881840"/>
                <a:tab algn="l" pos="8407440"/>
                <a:tab algn="l" pos="8933040"/>
                <a:tab algn="l" pos="9458280"/>
                <a:tab algn="l" pos="9983880"/>
                <a:tab algn="l" pos="1050912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220680" y="3301200"/>
            <a:ext cx="1905480" cy="179820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5600"/>
                <a:tab algn="l" pos="1050840"/>
                <a:tab algn="l" pos="1576440"/>
                <a:tab algn="l" pos="2101680"/>
                <a:tab algn="l" pos="2627280"/>
                <a:tab algn="l" pos="3152880"/>
                <a:tab algn="l" pos="3678120"/>
                <a:tab algn="l" pos="4203720"/>
                <a:tab algn="l" pos="4729320"/>
                <a:tab algn="l" pos="5254560"/>
                <a:tab algn="l" pos="5780160"/>
                <a:tab algn="l" pos="6305400"/>
                <a:tab algn="l" pos="6831000"/>
                <a:tab algn="l" pos="7356600"/>
                <a:tab algn="l" pos="7881840"/>
                <a:tab algn="l" pos="8407440"/>
                <a:tab algn="l" pos="8933040"/>
                <a:tab algn="l" pos="9458280"/>
                <a:tab algn="l" pos="9983880"/>
                <a:tab algn="l" pos="1050912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142962-98F3-4CDE-9266-8606E68649F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220680" y="228600"/>
            <a:ext cx="3905280" cy="95256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ctr">
            <a:noAutofit/>
          </a:bodyPr>
          <a:p>
            <a:pPr indent="0" algn="ctr">
              <a:buNone/>
              <a:tabLst>
                <a:tab algn="l" pos="0"/>
                <a:tab algn="l" pos="525600"/>
                <a:tab algn="l" pos="1050840"/>
                <a:tab algn="l" pos="1576440"/>
                <a:tab algn="l" pos="2101680"/>
                <a:tab algn="l" pos="2627280"/>
                <a:tab algn="l" pos="3152880"/>
                <a:tab algn="l" pos="3678120"/>
                <a:tab algn="l" pos="4203720"/>
                <a:tab algn="l" pos="4729320"/>
                <a:tab algn="l" pos="5254560"/>
                <a:tab algn="l" pos="5780160"/>
                <a:tab algn="l" pos="6305400"/>
                <a:tab algn="l" pos="6831000"/>
                <a:tab algn="l" pos="7356600"/>
                <a:tab algn="l" pos="7881840"/>
                <a:tab algn="l" pos="8407440"/>
                <a:tab algn="l" pos="8933040"/>
                <a:tab algn="l" pos="9458280"/>
                <a:tab algn="l" pos="9983880"/>
                <a:tab algn="l" pos="1050912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220680" y="1331640"/>
            <a:ext cx="1905480" cy="377028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5600"/>
                <a:tab algn="l" pos="1050840"/>
                <a:tab algn="l" pos="1576440"/>
                <a:tab algn="l" pos="2101680"/>
                <a:tab algn="l" pos="2627280"/>
                <a:tab algn="l" pos="3152880"/>
                <a:tab algn="l" pos="3678120"/>
                <a:tab algn="l" pos="4203720"/>
                <a:tab algn="l" pos="4729320"/>
                <a:tab algn="l" pos="5254560"/>
                <a:tab algn="l" pos="5780160"/>
                <a:tab algn="l" pos="6305400"/>
                <a:tab algn="l" pos="6831000"/>
                <a:tab algn="l" pos="7356600"/>
                <a:tab algn="l" pos="7881840"/>
                <a:tab algn="l" pos="8407440"/>
                <a:tab algn="l" pos="8933040"/>
                <a:tab algn="l" pos="9458280"/>
                <a:tab algn="l" pos="9983880"/>
                <a:tab algn="l" pos="1050912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2221920" y="1331640"/>
            <a:ext cx="1905480" cy="179820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5600"/>
                <a:tab algn="l" pos="1050840"/>
                <a:tab algn="l" pos="1576440"/>
                <a:tab algn="l" pos="2101680"/>
                <a:tab algn="l" pos="2627280"/>
                <a:tab algn="l" pos="3152880"/>
                <a:tab algn="l" pos="3678120"/>
                <a:tab algn="l" pos="4203720"/>
                <a:tab algn="l" pos="4729320"/>
                <a:tab algn="l" pos="5254560"/>
                <a:tab algn="l" pos="5780160"/>
                <a:tab algn="l" pos="6305400"/>
                <a:tab algn="l" pos="6831000"/>
                <a:tab algn="l" pos="7356600"/>
                <a:tab algn="l" pos="7881840"/>
                <a:tab algn="l" pos="8407440"/>
                <a:tab algn="l" pos="8933040"/>
                <a:tab algn="l" pos="9458280"/>
                <a:tab algn="l" pos="9983880"/>
                <a:tab algn="l" pos="1050912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2221920" y="3301200"/>
            <a:ext cx="1905480" cy="179820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5600"/>
                <a:tab algn="l" pos="1050840"/>
                <a:tab algn="l" pos="1576440"/>
                <a:tab algn="l" pos="2101680"/>
                <a:tab algn="l" pos="2627280"/>
                <a:tab algn="l" pos="3152880"/>
                <a:tab algn="l" pos="3678120"/>
                <a:tab algn="l" pos="4203720"/>
                <a:tab algn="l" pos="4729320"/>
                <a:tab algn="l" pos="5254560"/>
                <a:tab algn="l" pos="5780160"/>
                <a:tab algn="l" pos="6305400"/>
                <a:tab algn="l" pos="6831000"/>
                <a:tab algn="l" pos="7356600"/>
                <a:tab algn="l" pos="7881840"/>
                <a:tab algn="l" pos="8407440"/>
                <a:tab algn="l" pos="8933040"/>
                <a:tab algn="l" pos="9458280"/>
                <a:tab algn="l" pos="9983880"/>
                <a:tab algn="l" pos="1050912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DEC57F-AAAD-44F0-9C71-BF0F5DE8359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220680" y="228600"/>
            <a:ext cx="3905280" cy="95256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ctr">
            <a:noAutofit/>
          </a:bodyPr>
          <a:p>
            <a:pPr indent="0" algn="ctr">
              <a:buNone/>
              <a:tabLst>
                <a:tab algn="l" pos="0"/>
                <a:tab algn="l" pos="525600"/>
                <a:tab algn="l" pos="1050840"/>
                <a:tab algn="l" pos="1576440"/>
                <a:tab algn="l" pos="2101680"/>
                <a:tab algn="l" pos="2627280"/>
                <a:tab algn="l" pos="3152880"/>
                <a:tab algn="l" pos="3678120"/>
                <a:tab algn="l" pos="4203720"/>
                <a:tab algn="l" pos="4729320"/>
                <a:tab algn="l" pos="5254560"/>
                <a:tab algn="l" pos="5780160"/>
                <a:tab algn="l" pos="6305400"/>
                <a:tab algn="l" pos="6831000"/>
                <a:tab algn="l" pos="7356600"/>
                <a:tab algn="l" pos="7881840"/>
                <a:tab algn="l" pos="8407440"/>
                <a:tab algn="l" pos="8933040"/>
                <a:tab algn="l" pos="9458280"/>
                <a:tab algn="l" pos="9983880"/>
                <a:tab algn="l" pos="10509120"/>
              </a:tabLst>
            </a:pP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220680" y="1331640"/>
            <a:ext cx="1905480" cy="179820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5600"/>
                <a:tab algn="l" pos="1050840"/>
                <a:tab algn="l" pos="1576440"/>
                <a:tab algn="l" pos="2101680"/>
                <a:tab algn="l" pos="2627280"/>
                <a:tab algn="l" pos="3152880"/>
                <a:tab algn="l" pos="3678120"/>
                <a:tab algn="l" pos="4203720"/>
                <a:tab algn="l" pos="4729320"/>
                <a:tab algn="l" pos="5254560"/>
                <a:tab algn="l" pos="5780160"/>
                <a:tab algn="l" pos="6305400"/>
                <a:tab algn="l" pos="6831000"/>
                <a:tab algn="l" pos="7356600"/>
                <a:tab algn="l" pos="7881840"/>
                <a:tab algn="l" pos="8407440"/>
                <a:tab algn="l" pos="8933040"/>
                <a:tab algn="l" pos="9458280"/>
                <a:tab algn="l" pos="9983880"/>
                <a:tab algn="l" pos="1050912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2221920" y="1331640"/>
            <a:ext cx="1905480" cy="179820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5600"/>
                <a:tab algn="l" pos="1050840"/>
                <a:tab algn="l" pos="1576440"/>
                <a:tab algn="l" pos="2101680"/>
                <a:tab algn="l" pos="2627280"/>
                <a:tab algn="l" pos="3152880"/>
                <a:tab algn="l" pos="3678120"/>
                <a:tab algn="l" pos="4203720"/>
                <a:tab algn="l" pos="4729320"/>
                <a:tab algn="l" pos="5254560"/>
                <a:tab algn="l" pos="5780160"/>
                <a:tab algn="l" pos="6305400"/>
                <a:tab algn="l" pos="6831000"/>
                <a:tab algn="l" pos="7356600"/>
                <a:tab algn="l" pos="7881840"/>
                <a:tab algn="l" pos="8407440"/>
                <a:tab algn="l" pos="8933040"/>
                <a:tab algn="l" pos="9458280"/>
                <a:tab algn="l" pos="9983880"/>
                <a:tab algn="l" pos="1050912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220680" y="3301200"/>
            <a:ext cx="3905280" cy="179820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5600"/>
                <a:tab algn="l" pos="1050840"/>
                <a:tab algn="l" pos="1576440"/>
                <a:tab algn="l" pos="2101680"/>
                <a:tab algn="l" pos="2627280"/>
                <a:tab algn="l" pos="3152880"/>
                <a:tab algn="l" pos="3678120"/>
                <a:tab algn="l" pos="4203720"/>
                <a:tab algn="l" pos="4729320"/>
                <a:tab algn="l" pos="5254560"/>
                <a:tab algn="l" pos="5780160"/>
                <a:tab algn="l" pos="6305400"/>
                <a:tab algn="l" pos="6831000"/>
                <a:tab algn="l" pos="7356600"/>
                <a:tab algn="l" pos="7881840"/>
                <a:tab algn="l" pos="8407440"/>
                <a:tab algn="l" pos="8933040"/>
                <a:tab algn="l" pos="9458280"/>
                <a:tab algn="l" pos="9983880"/>
                <a:tab algn="l" pos="1050912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FE83A8-FF6F-426D-A646-B7053FE6087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220680" y="228600"/>
            <a:ext cx="3905280" cy="95256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ctr">
            <a:noAutofit/>
          </a:bodyPr>
          <a:p>
            <a:pPr indent="0" algn="ctr">
              <a:buNone/>
              <a:tabLst>
                <a:tab algn="l" pos="0"/>
                <a:tab algn="l" pos="525600"/>
                <a:tab algn="l" pos="1050840"/>
                <a:tab algn="l" pos="1576440"/>
                <a:tab algn="l" pos="2101680"/>
                <a:tab algn="l" pos="2627280"/>
                <a:tab algn="l" pos="3152880"/>
                <a:tab algn="l" pos="3678120"/>
                <a:tab algn="l" pos="4203720"/>
                <a:tab algn="l" pos="4729320"/>
                <a:tab algn="l" pos="5254560"/>
                <a:tab algn="l" pos="5780160"/>
                <a:tab algn="l" pos="6305400"/>
                <a:tab algn="l" pos="6831000"/>
                <a:tab algn="l" pos="7356600"/>
                <a:tab algn="l" pos="7881840"/>
                <a:tab algn="l" pos="8407440"/>
                <a:tab algn="l" pos="8933040"/>
                <a:tab algn="l" pos="9458280"/>
                <a:tab algn="l" pos="9983880"/>
                <a:tab algn="l" pos="1050912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220680" y="1331640"/>
            <a:ext cx="3905280" cy="377028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rmAutofit/>
          </a:bodyPr>
          <a:p>
            <a:pPr marL="196920" indent="-196920">
              <a:spcBef>
                <a:spcPts val="451"/>
              </a:spcBef>
              <a:buClr>
                <a:srgbClr val="000000"/>
              </a:buClr>
              <a:buFont typeface="Arial"/>
              <a:buChar char="•"/>
              <a:tabLst>
                <a:tab algn="l" pos="525600"/>
                <a:tab algn="l" pos="1050840"/>
                <a:tab algn="l" pos="1576440"/>
                <a:tab algn="l" pos="2101680"/>
                <a:tab algn="l" pos="2627280"/>
                <a:tab algn="l" pos="3152880"/>
                <a:tab algn="l" pos="3678120"/>
                <a:tab algn="l" pos="4203720"/>
                <a:tab algn="l" pos="4729320"/>
                <a:tab algn="l" pos="5254560"/>
                <a:tab algn="l" pos="5780160"/>
                <a:tab algn="l" pos="6305400"/>
                <a:tab algn="l" pos="6831000"/>
                <a:tab algn="l" pos="7356600"/>
                <a:tab algn="l" pos="7881840"/>
                <a:tab algn="l" pos="8407440"/>
                <a:tab algn="l" pos="8933040"/>
                <a:tab algn="l" pos="9458280"/>
                <a:tab algn="l" pos="9983880"/>
                <a:tab algn="l" pos="1050912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lvl="1" marL="426960" indent="-163440">
              <a:spcBef>
                <a:spcPts val="451"/>
              </a:spcBef>
              <a:buClr>
                <a:srgbClr val="000000"/>
              </a:buClr>
              <a:buFont typeface="Arial"/>
              <a:buChar char="–"/>
              <a:tabLst>
                <a:tab algn="l" pos="525600"/>
                <a:tab algn="l" pos="1050840"/>
                <a:tab algn="l" pos="1576440"/>
                <a:tab algn="l" pos="2101680"/>
                <a:tab algn="l" pos="2627280"/>
                <a:tab algn="l" pos="3152880"/>
                <a:tab algn="l" pos="3678120"/>
                <a:tab algn="l" pos="4203720"/>
                <a:tab algn="l" pos="4729320"/>
                <a:tab algn="l" pos="5254560"/>
                <a:tab algn="l" pos="5780160"/>
                <a:tab algn="l" pos="6305400"/>
                <a:tab algn="l" pos="6831000"/>
                <a:tab algn="l" pos="7356600"/>
                <a:tab algn="l" pos="7881840"/>
                <a:tab algn="l" pos="8407440"/>
                <a:tab algn="l" pos="8933040"/>
                <a:tab algn="l" pos="9458280"/>
                <a:tab algn="l" pos="9983880"/>
                <a:tab algn="l" pos="1050912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lvl="2" marL="655560" indent="-129960">
              <a:spcBef>
                <a:spcPts val="451"/>
              </a:spcBef>
              <a:buClr>
                <a:srgbClr val="000000"/>
              </a:buClr>
              <a:buFont typeface="Arial"/>
              <a:buChar char="•"/>
              <a:tabLst>
                <a:tab algn="l" pos="525600"/>
                <a:tab algn="l" pos="1050840"/>
                <a:tab algn="l" pos="1576440"/>
                <a:tab algn="l" pos="2101680"/>
                <a:tab algn="l" pos="2627280"/>
                <a:tab algn="l" pos="3152880"/>
                <a:tab algn="l" pos="3678120"/>
                <a:tab algn="l" pos="4203720"/>
                <a:tab algn="l" pos="4729320"/>
                <a:tab algn="l" pos="5254560"/>
                <a:tab algn="l" pos="5780160"/>
                <a:tab algn="l" pos="6305400"/>
                <a:tab algn="l" pos="6831000"/>
                <a:tab algn="l" pos="7356600"/>
                <a:tab algn="l" pos="7881840"/>
                <a:tab algn="l" pos="8407440"/>
                <a:tab algn="l" pos="8933040"/>
                <a:tab algn="l" pos="9458280"/>
                <a:tab algn="l" pos="9983880"/>
                <a:tab algn="l" pos="1050912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lvl="3" marL="919080" indent="-129960">
              <a:spcBef>
                <a:spcPts val="451"/>
              </a:spcBef>
              <a:buClr>
                <a:srgbClr val="000000"/>
              </a:buClr>
              <a:buFont typeface="Arial"/>
              <a:buChar char="–"/>
              <a:tabLst>
                <a:tab algn="l" pos="525600"/>
                <a:tab algn="l" pos="1050840"/>
                <a:tab algn="l" pos="1576440"/>
                <a:tab algn="l" pos="2101680"/>
                <a:tab algn="l" pos="2627280"/>
                <a:tab algn="l" pos="3152880"/>
                <a:tab algn="l" pos="3678120"/>
                <a:tab algn="l" pos="4203720"/>
                <a:tab algn="l" pos="4729320"/>
                <a:tab algn="l" pos="5254560"/>
                <a:tab algn="l" pos="5780160"/>
                <a:tab algn="l" pos="6305400"/>
                <a:tab algn="l" pos="6831000"/>
                <a:tab algn="l" pos="7356600"/>
                <a:tab algn="l" pos="7881840"/>
                <a:tab algn="l" pos="8407440"/>
                <a:tab algn="l" pos="8933040"/>
                <a:tab algn="l" pos="9458280"/>
                <a:tab algn="l" pos="9983880"/>
                <a:tab algn="l" pos="1050912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lvl="4" marL="1182600" indent="-133200">
              <a:spcBef>
                <a:spcPts val="451"/>
              </a:spcBef>
              <a:buClr>
                <a:srgbClr val="000000"/>
              </a:buClr>
              <a:buFont typeface="Arial"/>
              <a:buChar char="»"/>
              <a:tabLst>
                <a:tab algn="l" pos="525600"/>
                <a:tab algn="l" pos="1050840"/>
                <a:tab algn="l" pos="1576440"/>
                <a:tab algn="l" pos="2101680"/>
                <a:tab algn="l" pos="2627280"/>
                <a:tab algn="l" pos="3152880"/>
                <a:tab algn="l" pos="3678120"/>
                <a:tab algn="l" pos="4203720"/>
                <a:tab algn="l" pos="4729320"/>
                <a:tab algn="l" pos="5254560"/>
                <a:tab algn="l" pos="5780160"/>
                <a:tab algn="l" pos="6305400"/>
                <a:tab algn="l" pos="6831000"/>
                <a:tab algn="l" pos="7356600"/>
                <a:tab algn="l" pos="7881840"/>
                <a:tab algn="l" pos="8407440"/>
                <a:tab algn="l" pos="8933040"/>
                <a:tab algn="l" pos="9458280"/>
                <a:tab algn="l" pos="9983880"/>
                <a:tab algn="l" pos="1050912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lvl="5" marL="1182600" indent="-133200">
              <a:spcBef>
                <a:spcPts val="451"/>
              </a:spcBef>
              <a:buClr>
                <a:srgbClr val="000000"/>
              </a:buClr>
              <a:buFont typeface="Arial"/>
              <a:buChar char="»"/>
              <a:tabLst>
                <a:tab algn="l" pos="525600"/>
                <a:tab algn="l" pos="1050840"/>
                <a:tab algn="l" pos="1576440"/>
                <a:tab algn="l" pos="2101680"/>
                <a:tab algn="l" pos="2627280"/>
                <a:tab algn="l" pos="3152880"/>
                <a:tab algn="l" pos="3678120"/>
                <a:tab algn="l" pos="4203720"/>
                <a:tab algn="l" pos="4729320"/>
                <a:tab algn="l" pos="5254560"/>
                <a:tab algn="l" pos="5780160"/>
                <a:tab algn="l" pos="6305400"/>
                <a:tab algn="l" pos="6831000"/>
                <a:tab algn="l" pos="7356600"/>
                <a:tab algn="l" pos="7881840"/>
                <a:tab algn="l" pos="8407440"/>
                <a:tab algn="l" pos="8933040"/>
                <a:tab algn="l" pos="9458280"/>
                <a:tab algn="l" pos="9983880"/>
                <a:tab algn="l" pos="1050912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lvl="6" marL="1182600" indent="-133200">
              <a:spcBef>
                <a:spcPts val="451"/>
              </a:spcBef>
              <a:buClr>
                <a:srgbClr val="000000"/>
              </a:buClr>
              <a:buFont typeface="Arial"/>
              <a:buChar char="»"/>
              <a:tabLst>
                <a:tab algn="l" pos="525600"/>
                <a:tab algn="l" pos="1050840"/>
                <a:tab algn="l" pos="1576440"/>
                <a:tab algn="l" pos="2101680"/>
                <a:tab algn="l" pos="2627280"/>
                <a:tab algn="l" pos="3152880"/>
                <a:tab algn="l" pos="3678120"/>
                <a:tab algn="l" pos="4203720"/>
                <a:tab algn="l" pos="4729320"/>
                <a:tab algn="l" pos="5254560"/>
                <a:tab algn="l" pos="5780160"/>
                <a:tab algn="l" pos="6305400"/>
                <a:tab algn="l" pos="6831000"/>
                <a:tab algn="l" pos="7356600"/>
                <a:tab algn="l" pos="7881840"/>
                <a:tab algn="l" pos="8407440"/>
                <a:tab algn="l" pos="8933040"/>
                <a:tab algn="l" pos="9458280"/>
                <a:tab algn="l" pos="9983880"/>
                <a:tab algn="l" pos="1050912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220320" y="5202360"/>
            <a:ext cx="1009800" cy="39672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1487520" y="5202360"/>
            <a:ext cx="1371600" cy="39672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3115800" y="5202360"/>
            <a:ext cx="1009800" cy="396720"/>
          </a:xfrm>
          <a:prstGeom prst="rect">
            <a:avLst/>
          </a:prstGeom>
          <a:noFill/>
          <a:ln w="0">
            <a:noFill/>
          </a:ln>
        </p:spPr>
        <p:txBody>
          <a:bodyPr lIns="52560" rIns="52560" tIns="26280" bIns="26280" anchor="t">
            <a:noAutofit/>
          </a:bodyPr>
          <a:lstStyle>
            <a:lvl1pPr indent="0" algn="r">
              <a:buNone/>
              <a:tabLst>
                <a:tab algn="l" pos="0"/>
                <a:tab algn="l" pos="525600"/>
                <a:tab algn="l" pos="1050840"/>
                <a:tab algn="l" pos="1576440"/>
                <a:tab algn="l" pos="2101680"/>
                <a:tab algn="l" pos="2627280"/>
                <a:tab algn="l" pos="3152880"/>
                <a:tab algn="l" pos="3678120"/>
                <a:tab algn="l" pos="4203720"/>
                <a:tab algn="l" pos="4729320"/>
                <a:tab algn="l" pos="5254560"/>
                <a:tab algn="l" pos="5780160"/>
                <a:tab algn="l" pos="6305400"/>
                <a:tab algn="l" pos="6831000"/>
                <a:tab algn="l" pos="7356600"/>
                <a:tab algn="l" pos="7881840"/>
                <a:tab algn="l" pos="8407440"/>
                <a:tab algn="l" pos="8933040"/>
                <a:tab algn="l" pos="9458280"/>
                <a:tab algn="l" pos="9983880"/>
                <a:tab algn="l" pos="10509120"/>
              </a:tabLst>
              <a:defRPr b="0" lang="en-US" sz="8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525600"/>
                <a:tab algn="l" pos="1050840"/>
                <a:tab algn="l" pos="1576440"/>
                <a:tab algn="l" pos="2101680"/>
                <a:tab algn="l" pos="2627280"/>
                <a:tab algn="l" pos="3152880"/>
                <a:tab algn="l" pos="3678120"/>
                <a:tab algn="l" pos="4203720"/>
                <a:tab algn="l" pos="4729320"/>
                <a:tab algn="l" pos="5254560"/>
                <a:tab algn="l" pos="5780160"/>
                <a:tab algn="l" pos="6305400"/>
                <a:tab algn="l" pos="6831000"/>
                <a:tab algn="l" pos="7356600"/>
                <a:tab algn="l" pos="7881840"/>
                <a:tab algn="l" pos="8407440"/>
                <a:tab algn="l" pos="8933040"/>
                <a:tab algn="l" pos="9458280"/>
                <a:tab algn="l" pos="9983880"/>
                <a:tab algn="l" pos="10509120"/>
              </a:tabLst>
            </a:pPr>
            <a:fld id="{F0084141-222A-47D2-AD2D-786E95BC76C5}" type="slidenum">
              <a:rPr b="0" lang="en-US" sz="8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5.png"/><Relationship Id="rId7" Type="http://schemas.openxmlformats.org/officeDocument/2006/relationships/image" Target="../media/image5.png"/><Relationship Id="rId8" Type="http://schemas.openxmlformats.org/officeDocument/2006/relationships/image" Target="../media/image5.png"/><Relationship Id="rId9" Type="http://schemas.openxmlformats.org/officeDocument/2006/relationships/image" Target="../media/image4.png"/><Relationship Id="rId10" Type="http://schemas.openxmlformats.org/officeDocument/2006/relationships/image" Target="../media/image5.png"/><Relationship Id="rId11" Type="http://schemas.openxmlformats.org/officeDocument/2006/relationships/image" Target="../media/image6.wmf"/><Relationship Id="rId12" Type="http://schemas.openxmlformats.org/officeDocument/2006/relationships/image" Target="../media/image5.png"/><Relationship Id="rId13" Type="http://schemas.openxmlformats.org/officeDocument/2006/relationships/image" Target="../media/image5.png"/><Relationship Id="rId14" Type="http://schemas.openxmlformats.org/officeDocument/2006/relationships/image" Target="../media/image5.png"/><Relationship Id="rId1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-55800" y="-22320"/>
            <a:ext cx="4473360" cy="5795640"/>
            <a:chOff x="-55800" y="-22320"/>
            <a:chExt cx="4473360" cy="5795640"/>
          </a:xfrm>
        </p:grpSpPr>
        <p:pic>
          <p:nvPicPr>
            <p:cNvPr id="42" name="Picture 4" descr=""/>
            <p:cNvPicPr/>
            <p:nvPr/>
          </p:nvPicPr>
          <p:blipFill>
            <a:blip r:embed="rId1"/>
            <a:stretch/>
          </p:blipFill>
          <p:spPr>
            <a:xfrm>
              <a:off x="455400" y="860400"/>
              <a:ext cx="1396800" cy="1773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3" name="Picture 5" descr=""/>
            <p:cNvPicPr/>
            <p:nvPr/>
          </p:nvPicPr>
          <p:blipFill>
            <a:blip r:embed="rId2"/>
            <a:stretch/>
          </p:blipFill>
          <p:spPr>
            <a:xfrm>
              <a:off x="2466720" y="839520"/>
              <a:ext cx="1598760" cy="17956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4" name="Text Box 6"/>
            <p:cNvSpPr/>
            <p:nvPr/>
          </p:nvSpPr>
          <p:spPr>
            <a:xfrm>
              <a:off x="2453760" y="-22320"/>
              <a:ext cx="1849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VPaI-3 (VP1071-VP1095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Text Box 7"/>
            <p:cNvSpPr/>
            <p:nvPr/>
          </p:nvSpPr>
          <p:spPr>
            <a:xfrm>
              <a:off x="229680" y="-20520"/>
              <a:ext cx="1849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VPaI-2 (VP0634-VP0643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6" name="Picture 8" descr=""/>
            <p:cNvPicPr/>
            <p:nvPr/>
          </p:nvPicPr>
          <p:blipFill>
            <a:blip r:embed="rId3"/>
            <a:stretch/>
          </p:blipFill>
          <p:spPr>
            <a:xfrm>
              <a:off x="477720" y="3286080"/>
              <a:ext cx="1145880" cy="1790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7" name="Text Box 51"/>
            <p:cNvSpPr/>
            <p:nvPr/>
          </p:nvSpPr>
          <p:spPr>
            <a:xfrm>
              <a:off x="2381040" y="666720"/>
              <a:ext cx="846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Helicas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Line 73"/>
            <p:cNvSpPr/>
            <p:nvPr/>
          </p:nvSpPr>
          <p:spPr>
            <a:xfrm flipV="1">
              <a:off x="2241360" y="2928600"/>
              <a:ext cx="1925640" cy="4680"/>
            </a:xfrm>
            <a:prstGeom prst="line">
              <a:avLst/>
            </a:prstGeom>
            <a:ln w="176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Freeform 75"/>
            <p:cNvSpPr/>
            <p:nvPr/>
          </p:nvSpPr>
          <p:spPr>
            <a:xfrm flipH="1">
              <a:off x="2721600" y="2778120"/>
              <a:ext cx="57240" cy="318960"/>
            </a:xfrm>
            <a:prstGeom prst="pie">
              <a:avLst/>
            </a:prstGeom>
            <a:blipFill rotWithShape="0">
              <a:blip r:embed="rId4"/>
              <a:srcRect/>
              <a:tile tx="0" ty="0" sx="100000" sy="100000" algn="ctr"/>
            </a:blipFill>
            <a:ln cap="rnd"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Freeform 76"/>
            <p:cNvSpPr/>
            <p:nvPr/>
          </p:nvSpPr>
          <p:spPr>
            <a:xfrm flipH="1">
              <a:off x="2372400" y="2771640"/>
              <a:ext cx="49320" cy="318960"/>
            </a:xfrm>
            <a:prstGeom prst="pie">
              <a:avLst/>
            </a:prstGeom>
            <a:blipFill rotWithShape="0">
              <a:blip r:embed="rId5"/>
              <a:srcRect/>
              <a:tile tx="0" ty="0" sx="100000" sy="100000" algn="ctr"/>
            </a:blipFill>
            <a:ln cap="rnd"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Freeform 77"/>
            <p:cNvSpPr/>
            <p:nvPr/>
          </p:nvSpPr>
          <p:spPr>
            <a:xfrm flipH="1">
              <a:off x="3046320" y="2771640"/>
              <a:ext cx="196560" cy="324000"/>
            </a:xfrm>
            <a:prstGeom prst="pie">
              <a:avLst/>
            </a:prstGeom>
            <a:solidFill>
              <a:srgbClr val="80808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Freeform 78"/>
            <p:cNvSpPr/>
            <p:nvPr/>
          </p:nvSpPr>
          <p:spPr>
            <a:xfrm>
              <a:off x="3974760" y="2771640"/>
              <a:ext cx="49320" cy="324000"/>
            </a:xfrm>
            <a:prstGeom prst="pie">
              <a:avLst/>
            </a:prstGeom>
            <a:solidFill>
              <a:srgbClr val="80808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Freeform 79"/>
            <p:cNvSpPr/>
            <p:nvPr/>
          </p:nvSpPr>
          <p:spPr>
            <a:xfrm flipH="1">
              <a:off x="4031280" y="2771640"/>
              <a:ext cx="27000" cy="324000"/>
            </a:xfrm>
            <a:prstGeom prst="pie">
              <a:avLst/>
            </a:prstGeom>
            <a:solidFill>
              <a:srgbClr val="80808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Freeform 80"/>
            <p:cNvSpPr/>
            <p:nvPr/>
          </p:nvSpPr>
          <p:spPr>
            <a:xfrm flipH="1">
              <a:off x="3935880" y="2771640"/>
              <a:ext cx="25560" cy="324000"/>
            </a:xfrm>
            <a:prstGeom prst="pie">
              <a:avLst/>
            </a:prstGeom>
            <a:solidFill>
              <a:srgbClr val="80808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Freeform 81"/>
            <p:cNvSpPr/>
            <p:nvPr/>
          </p:nvSpPr>
          <p:spPr>
            <a:xfrm flipH="1">
              <a:off x="3731400" y="2778120"/>
              <a:ext cx="198360" cy="322200"/>
            </a:xfrm>
            <a:prstGeom prst="pie">
              <a:avLst/>
            </a:prstGeom>
            <a:solidFill>
              <a:srgbClr val="80808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Rectangle 82"/>
            <p:cNvSpPr/>
            <p:nvPr/>
          </p:nvSpPr>
          <p:spPr>
            <a:xfrm>
              <a:off x="4076280" y="2835000"/>
              <a:ext cx="27000" cy="18108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Rectangle 83"/>
            <p:cNvSpPr/>
            <p:nvPr/>
          </p:nvSpPr>
          <p:spPr>
            <a:xfrm>
              <a:off x="2315880" y="2841480"/>
              <a:ext cx="39600" cy="16524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Rectangle 84"/>
            <p:cNvSpPr/>
            <p:nvPr/>
          </p:nvSpPr>
          <p:spPr>
            <a:xfrm>
              <a:off x="2296800" y="2841480"/>
              <a:ext cx="39600" cy="165240"/>
            </a:xfrm>
            <a:prstGeom prst="rect">
              <a:avLst/>
            </a:prstGeom>
            <a:solidFill>
              <a:srgbClr val="bbe0e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Text Box 86"/>
            <p:cNvSpPr/>
            <p:nvPr/>
          </p:nvSpPr>
          <p:spPr>
            <a:xfrm>
              <a:off x="3847680" y="2533680"/>
              <a:ext cx="487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D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Text Box 87"/>
            <p:cNvSpPr/>
            <p:nvPr/>
          </p:nvSpPr>
          <p:spPr>
            <a:xfrm>
              <a:off x="2481120" y="2525760"/>
              <a:ext cx="425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In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Text Box 88"/>
            <p:cNvSpPr/>
            <p:nvPr/>
          </p:nvSpPr>
          <p:spPr>
            <a:xfrm>
              <a:off x="2217600" y="2535120"/>
              <a:ext cx="426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D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Line 89"/>
            <p:cNvSpPr/>
            <p:nvPr/>
          </p:nvSpPr>
          <p:spPr>
            <a:xfrm>
              <a:off x="2325600" y="2700360"/>
              <a:ext cx="18720" cy="188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Line 90"/>
            <p:cNvSpPr/>
            <p:nvPr/>
          </p:nvSpPr>
          <p:spPr>
            <a:xfrm flipH="1">
              <a:off x="2379240" y="2687400"/>
              <a:ext cx="252720" cy="212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Line 91"/>
            <p:cNvSpPr/>
            <p:nvPr/>
          </p:nvSpPr>
          <p:spPr>
            <a:xfrm flipH="1" flipV="1">
              <a:off x="2188440" y="2774880"/>
              <a:ext cx="117720" cy="154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Text Box 92"/>
            <p:cNvSpPr/>
            <p:nvPr/>
          </p:nvSpPr>
          <p:spPr>
            <a:xfrm>
              <a:off x="1858680" y="2652480"/>
              <a:ext cx="623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tRN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Line 93"/>
            <p:cNvSpPr/>
            <p:nvPr/>
          </p:nvSpPr>
          <p:spPr>
            <a:xfrm flipV="1">
              <a:off x="4090680" y="2733120"/>
              <a:ext cx="15840" cy="189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Line 95"/>
            <p:cNvSpPr/>
            <p:nvPr/>
          </p:nvSpPr>
          <p:spPr>
            <a:xfrm>
              <a:off x="2631960" y="2687400"/>
              <a:ext cx="98280" cy="208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Rectangle 96"/>
            <p:cNvSpPr/>
            <p:nvPr/>
          </p:nvSpPr>
          <p:spPr>
            <a:xfrm>
              <a:off x="3250800" y="2854080"/>
              <a:ext cx="463680" cy="162000"/>
            </a:xfrm>
            <a:prstGeom prst="rect">
              <a:avLst/>
            </a:prstGeom>
            <a:solidFill>
              <a:srgbClr val="80808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Rectangle 98"/>
            <p:cNvSpPr/>
            <p:nvPr/>
          </p:nvSpPr>
          <p:spPr>
            <a:xfrm>
              <a:off x="2782800" y="2854080"/>
              <a:ext cx="245880" cy="152640"/>
            </a:xfrm>
            <a:prstGeom prst="rect">
              <a:avLst/>
            </a:prstGeom>
            <a:solidFill>
              <a:srgbClr val="80808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Freeform 99"/>
            <p:cNvSpPr/>
            <p:nvPr/>
          </p:nvSpPr>
          <p:spPr>
            <a:xfrm flipH="1">
              <a:off x="2441160" y="2768400"/>
              <a:ext cx="74880" cy="324000"/>
            </a:xfrm>
            <a:prstGeom prst="pi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Freeform 100"/>
            <p:cNvSpPr/>
            <p:nvPr/>
          </p:nvSpPr>
          <p:spPr>
            <a:xfrm flipH="1">
              <a:off x="2616840" y="2768400"/>
              <a:ext cx="74520" cy="324000"/>
            </a:xfrm>
            <a:prstGeom prst="pi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Freeform 101"/>
            <p:cNvSpPr/>
            <p:nvPr/>
          </p:nvSpPr>
          <p:spPr>
            <a:xfrm flipH="1">
              <a:off x="2529360" y="2768400"/>
              <a:ext cx="25560" cy="324000"/>
            </a:xfrm>
            <a:prstGeom prst="pi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Freeform 102"/>
            <p:cNvSpPr/>
            <p:nvPr/>
          </p:nvSpPr>
          <p:spPr>
            <a:xfrm flipH="1">
              <a:off x="2578680" y="2768400"/>
              <a:ext cx="25560" cy="324000"/>
            </a:xfrm>
            <a:prstGeom prst="pi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Line 105"/>
            <p:cNvSpPr/>
            <p:nvPr/>
          </p:nvSpPr>
          <p:spPr>
            <a:xfrm flipV="1">
              <a:off x="334800" y="2907720"/>
              <a:ext cx="1377720" cy="3240"/>
            </a:xfrm>
            <a:prstGeom prst="line">
              <a:avLst/>
            </a:prstGeom>
            <a:ln w="176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Text Box 114"/>
            <p:cNvSpPr/>
            <p:nvPr/>
          </p:nvSpPr>
          <p:spPr>
            <a:xfrm>
              <a:off x="1398240" y="2535120"/>
              <a:ext cx="711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tmRN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76" name="Group 138"/>
            <p:cNvGrpSpPr/>
            <p:nvPr/>
          </p:nvGrpSpPr>
          <p:grpSpPr>
            <a:xfrm>
              <a:off x="467640" y="2755800"/>
              <a:ext cx="1200240" cy="316080"/>
              <a:chOff x="467640" y="2755800"/>
              <a:chExt cx="1200240" cy="316080"/>
            </a:xfrm>
          </p:grpSpPr>
          <p:sp>
            <p:nvSpPr>
              <p:cNvPr id="77" name="Rectangle 108"/>
              <p:cNvSpPr/>
              <p:nvPr/>
            </p:nvSpPr>
            <p:spPr>
              <a:xfrm>
                <a:off x="1504080" y="2836440"/>
                <a:ext cx="40680" cy="154080"/>
              </a:xfrm>
              <a:prstGeom prst="rect">
                <a:avLst/>
              </a:prstGeom>
              <a:solidFill>
                <a:srgbClr val="bbe0e3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Rectangle 110"/>
              <p:cNvSpPr/>
              <p:nvPr/>
            </p:nvSpPr>
            <p:spPr>
              <a:xfrm>
                <a:off x="831600" y="2842560"/>
                <a:ext cx="230760" cy="14328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AutoShape 111"/>
              <p:cNvSpPr/>
              <p:nvPr/>
            </p:nvSpPr>
            <p:spPr>
              <a:xfrm flipH="1">
                <a:off x="467280" y="2763000"/>
                <a:ext cx="102600" cy="305280"/>
              </a:xfrm>
              <a:prstGeom prst="rightArrow">
                <a:avLst>
                  <a:gd name="adj1" fmla="val 50000"/>
                  <a:gd name="adj2" fmla="val 25000"/>
                </a:avLst>
              </a:prstGeom>
              <a:solidFill>
                <a:srgbClr val="80808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AutoShape 112"/>
              <p:cNvSpPr/>
              <p:nvPr/>
            </p:nvSpPr>
            <p:spPr>
              <a:xfrm rot="10800000">
                <a:off x="1378440" y="2755800"/>
                <a:ext cx="105120" cy="316080"/>
              </a:xfrm>
              <a:prstGeom prst="rightArrow">
                <a:avLst>
                  <a:gd name="adj1" fmla="val 50000"/>
                  <a:gd name="adj2" fmla="val 25000"/>
                </a:avLst>
              </a:prstGeom>
              <a:blipFill rotWithShape="0">
                <a:blip r:embed="rId6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 rot="10800000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AutoShape 113"/>
              <p:cNvSpPr/>
              <p:nvPr/>
            </p:nvSpPr>
            <p:spPr>
              <a:xfrm flipH="1">
                <a:off x="1322280" y="2763000"/>
                <a:ext cx="38160" cy="305280"/>
              </a:xfrm>
              <a:prstGeom prst="rightArrow">
                <a:avLst>
                  <a:gd name="adj1" fmla="val 50000"/>
                  <a:gd name="adj2" fmla="val 25000"/>
                </a:avLst>
              </a:prstGeom>
              <a:blipFill rotWithShape="0">
                <a:blip r:embed="rId7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Line 115"/>
              <p:cNvSpPr/>
              <p:nvPr/>
            </p:nvSpPr>
            <p:spPr>
              <a:xfrm flipH="1">
                <a:off x="1508040" y="2773800"/>
                <a:ext cx="159840" cy="93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AutoShape 122"/>
              <p:cNvSpPr/>
              <p:nvPr/>
            </p:nvSpPr>
            <p:spPr>
              <a:xfrm flipH="1">
                <a:off x="582840" y="2763000"/>
                <a:ext cx="74880" cy="305280"/>
              </a:xfrm>
              <a:prstGeom prst="rightArrow">
                <a:avLst>
                  <a:gd name="adj1" fmla="val 50000"/>
                  <a:gd name="adj2" fmla="val 25000"/>
                </a:avLst>
              </a:prstGeom>
              <a:solidFill>
                <a:srgbClr val="80808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AutoShape 123"/>
              <p:cNvSpPr/>
              <p:nvPr/>
            </p:nvSpPr>
            <p:spPr>
              <a:xfrm>
                <a:off x="675720" y="2757960"/>
                <a:ext cx="69120" cy="305280"/>
              </a:xfrm>
              <a:prstGeom prst="rightArrow">
                <a:avLst>
                  <a:gd name="adj1" fmla="val 50000"/>
                  <a:gd name="adj2" fmla="val 25000"/>
                </a:avLst>
              </a:prstGeom>
              <a:solidFill>
                <a:srgbClr val="80808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AutoShape 124"/>
              <p:cNvSpPr/>
              <p:nvPr/>
            </p:nvSpPr>
            <p:spPr>
              <a:xfrm flipH="1">
                <a:off x="1081440" y="2763000"/>
                <a:ext cx="87120" cy="305280"/>
              </a:xfrm>
              <a:prstGeom prst="rightArrow">
                <a:avLst>
                  <a:gd name="adj1" fmla="val 50000"/>
                  <a:gd name="adj2" fmla="val 25000"/>
                </a:avLst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AutoShape 125"/>
              <p:cNvSpPr/>
              <p:nvPr/>
            </p:nvSpPr>
            <p:spPr>
              <a:xfrm flipH="1">
                <a:off x="1190160" y="2757960"/>
                <a:ext cx="109080" cy="305280"/>
              </a:xfrm>
              <a:prstGeom prst="rightArrow">
                <a:avLst>
                  <a:gd name="adj1" fmla="val 50000"/>
                  <a:gd name="adj2" fmla="val 25000"/>
                </a:avLst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7" name="Text Box 29"/>
            <p:cNvSpPr/>
            <p:nvPr/>
          </p:nvSpPr>
          <p:spPr>
            <a:xfrm>
              <a:off x="1188720" y="164880"/>
              <a:ext cx="397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In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Text Box 34"/>
            <p:cNvSpPr/>
            <p:nvPr/>
          </p:nvSpPr>
          <p:spPr>
            <a:xfrm>
              <a:off x="1371240" y="669960"/>
              <a:ext cx="1200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ribonuclease HI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Text Box 36"/>
            <p:cNvSpPr/>
            <p:nvPr/>
          </p:nvSpPr>
          <p:spPr>
            <a:xfrm>
              <a:off x="590400" y="671400"/>
              <a:ext cx="920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Resolvas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Line 17"/>
            <p:cNvSpPr/>
            <p:nvPr/>
          </p:nvSpPr>
          <p:spPr>
            <a:xfrm flipV="1">
              <a:off x="196560" y="582120"/>
              <a:ext cx="1617840" cy="3240"/>
            </a:xfrm>
            <a:prstGeom prst="line">
              <a:avLst/>
            </a:prstGeom>
            <a:ln w="176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Rectangle 20"/>
            <p:cNvSpPr/>
            <p:nvPr/>
          </p:nvSpPr>
          <p:spPr>
            <a:xfrm>
              <a:off x="1595160" y="506160"/>
              <a:ext cx="41400" cy="154080"/>
            </a:xfrm>
            <a:prstGeom prst="rect">
              <a:avLst/>
            </a:prstGeom>
            <a:solidFill>
              <a:srgbClr val="bbe0e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Rectangle 21"/>
            <p:cNvSpPr/>
            <p:nvPr/>
          </p:nvSpPr>
          <p:spPr>
            <a:xfrm>
              <a:off x="674280" y="517320"/>
              <a:ext cx="439920" cy="1429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Rectangle 22"/>
            <p:cNvSpPr/>
            <p:nvPr/>
          </p:nvSpPr>
          <p:spPr>
            <a:xfrm>
              <a:off x="1201320" y="517320"/>
              <a:ext cx="182880" cy="1429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AutoShape 23"/>
            <p:cNvSpPr/>
            <p:nvPr/>
          </p:nvSpPr>
          <p:spPr>
            <a:xfrm>
              <a:off x="1128600" y="438120"/>
              <a:ext cx="52200" cy="30456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AutoShape 24"/>
            <p:cNvSpPr/>
            <p:nvPr/>
          </p:nvSpPr>
          <p:spPr>
            <a:xfrm rot="10800000">
              <a:off x="1463400" y="429840"/>
              <a:ext cx="106560" cy="315720"/>
            </a:xfrm>
            <a:prstGeom prst="rightArrow">
              <a:avLst>
                <a:gd name="adj1" fmla="val 50000"/>
                <a:gd name="adj2" fmla="val 25000"/>
              </a:avLst>
            </a:prstGeom>
            <a:blipFill rotWithShape="0">
              <a:blip r:embed="rId8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 rot="10800000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AutoShape 25"/>
            <p:cNvSpPr/>
            <p:nvPr/>
          </p:nvSpPr>
          <p:spPr>
            <a:xfrm>
              <a:off x="1392120" y="438120"/>
              <a:ext cx="60120" cy="30456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Text Box 26"/>
            <p:cNvSpPr/>
            <p:nvPr/>
          </p:nvSpPr>
          <p:spPr>
            <a:xfrm>
              <a:off x="1423800" y="223560"/>
              <a:ext cx="652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tmRN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Line 27"/>
            <p:cNvSpPr/>
            <p:nvPr/>
          </p:nvSpPr>
          <p:spPr>
            <a:xfrm flipH="1">
              <a:off x="1626840" y="395280"/>
              <a:ext cx="61920" cy="142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Line 30"/>
            <p:cNvSpPr/>
            <p:nvPr/>
          </p:nvSpPr>
          <p:spPr>
            <a:xfrm>
              <a:off x="1373040" y="377640"/>
              <a:ext cx="153720" cy="200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Line 35"/>
            <p:cNvSpPr/>
            <p:nvPr/>
          </p:nvSpPr>
          <p:spPr>
            <a:xfrm flipH="1" flipV="1">
              <a:off x="1416960" y="588600"/>
              <a:ext cx="41400" cy="183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Line 37"/>
            <p:cNvSpPr/>
            <p:nvPr/>
          </p:nvSpPr>
          <p:spPr>
            <a:xfrm flipH="1">
              <a:off x="996480" y="598320"/>
              <a:ext cx="160200" cy="139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AutoShape 126"/>
            <p:cNvSpPr/>
            <p:nvPr/>
          </p:nvSpPr>
          <p:spPr>
            <a:xfrm flipH="1">
              <a:off x="311760" y="442800"/>
              <a:ext cx="103320" cy="30492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80808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AutoShape 127"/>
            <p:cNvSpPr/>
            <p:nvPr/>
          </p:nvSpPr>
          <p:spPr>
            <a:xfrm flipH="1">
              <a:off x="427680" y="442800"/>
              <a:ext cx="74520" cy="30492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80808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AutoShape 128"/>
            <p:cNvSpPr/>
            <p:nvPr/>
          </p:nvSpPr>
          <p:spPr>
            <a:xfrm>
              <a:off x="526680" y="438120"/>
              <a:ext cx="68400" cy="30456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80808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Line 129"/>
            <p:cNvSpPr/>
            <p:nvPr/>
          </p:nvSpPr>
          <p:spPr>
            <a:xfrm flipV="1">
              <a:off x="760320" y="2419200"/>
              <a:ext cx="350640" cy="479520"/>
            </a:xfrm>
            <a:prstGeom prst="line">
              <a:avLst/>
            </a:prstGeom>
            <a:ln w="19080">
              <a:solidFill>
                <a:srgbClr val="00000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Line 130"/>
            <p:cNvSpPr/>
            <p:nvPr/>
          </p:nvSpPr>
          <p:spPr>
            <a:xfrm flipH="1" flipV="1">
              <a:off x="1397880" y="2403000"/>
              <a:ext cx="95400" cy="530280"/>
            </a:xfrm>
            <a:prstGeom prst="line">
              <a:avLst/>
            </a:prstGeom>
            <a:ln w="19080">
              <a:solidFill>
                <a:srgbClr val="00000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Line 131"/>
            <p:cNvSpPr/>
            <p:nvPr/>
          </p:nvSpPr>
          <p:spPr>
            <a:xfrm flipH="1" flipV="1">
              <a:off x="604440" y="593280"/>
              <a:ext cx="519120" cy="452520"/>
            </a:xfrm>
            <a:prstGeom prst="line">
              <a:avLst/>
            </a:prstGeom>
            <a:ln w="19080">
              <a:solidFill>
                <a:srgbClr val="00000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Line 132"/>
            <p:cNvSpPr/>
            <p:nvPr/>
          </p:nvSpPr>
          <p:spPr>
            <a:xfrm flipV="1">
              <a:off x="1349280" y="588600"/>
              <a:ext cx="228600" cy="468360"/>
            </a:xfrm>
            <a:prstGeom prst="line">
              <a:avLst/>
            </a:prstGeom>
            <a:ln w="19080">
              <a:solidFill>
                <a:srgbClr val="00000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Line 133"/>
            <p:cNvSpPr/>
            <p:nvPr/>
          </p:nvSpPr>
          <p:spPr>
            <a:xfrm flipH="1" flipV="1">
              <a:off x="2474640" y="600120"/>
              <a:ext cx="587520" cy="388800"/>
            </a:xfrm>
            <a:prstGeom prst="line">
              <a:avLst/>
            </a:prstGeom>
            <a:ln w="19080">
              <a:solidFill>
                <a:srgbClr val="00000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Line 134"/>
            <p:cNvSpPr/>
            <p:nvPr/>
          </p:nvSpPr>
          <p:spPr>
            <a:xfrm flipH="1" flipV="1">
              <a:off x="2841480" y="566280"/>
              <a:ext cx="420480" cy="415800"/>
            </a:xfrm>
            <a:prstGeom prst="line">
              <a:avLst/>
            </a:prstGeom>
            <a:ln w="19080">
              <a:solidFill>
                <a:srgbClr val="00000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Line 135"/>
            <p:cNvSpPr/>
            <p:nvPr/>
          </p:nvSpPr>
          <p:spPr>
            <a:xfrm flipV="1">
              <a:off x="2572920" y="2407680"/>
              <a:ext cx="587520" cy="513000"/>
            </a:xfrm>
            <a:prstGeom prst="line">
              <a:avLst/>
            </a:prstGeom>
            <a:ln w="19080">
              <a:solidFill>
                <a:srgbClr val="00000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Line 136"/>
            <p:cNvSpPr/>
            <p:nvPr/>
          </p:nvSpPr>
          <p:spPr>
            <a:xfrm flipV="1">
              <a:off x="2912760" y="2417400"/>
              <a:ext cx="446040" cy="507960"/>
            </a:xfrm>
            <a:prstGeom prst="line">
              <a:avLst/>
            </a:prstGeom>
            <a:ln w="19080">
              <a:solidFill>
                <a:srgbClr val="00000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13" name="Group 159"/>
            <p:cNvGrpSpPr/>
            <p:nvPr/>
          </p:nvGrpSpPr>
          <p:grpSpPr>
            <a:xfrm>
              <a:off x="1957320" y="126720"/>
              <a:ext cx="2460240" cy="623880"/>
              <a:chOff x="1957320" y="126720"/>
              <a:chExt cx="2460240" cy="623880"/>
            </a:xfrm>
          </p:grpSpPr>
          <p:sp>
            <p:nvSpPr>
              <p:cNvPr id="114" name="Line 39"/>
              <p:cNvSpPr/>
              <p:nvPr/>
            </p:nvSpPr>
            <p:spPr>
              <a:xfrm flipV="1">
                <a:off x="2340000" y="544680"/>
                <a:ext cx="1924920" cy="4680"/>
              </a:xfrm>
              <a:prstGeom prst="line">
                <a:avLst/>
              </a:prstGeom>
              <a:ln w="176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Freeform 41"/>
              <p:cNvSpPr/>
              <p:nvPr/>
            </p:nvSpPr>
            <p:spPr>
              <a:xfrm flipH="1">
                <a:off x="2820600" y="393480"/>
                <a:ext cx="55800" cy="319320"/>
              </a:xfrm>
              <a:prstGeom prst="pie">
                <a:avLst/>
              </a:prstGeom>
              <a:blipFill rotWithShape="0">
                <a:blip r:embed="rId9"/>
                <a:srcRect/>
                <a:tile tx="0" ty="0" sx="100000" sy="100000" algn="ctr"/>
              </a:blipFill>
              <a:ln cap="rnd"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Freeform 40"/>
              <p:cNvSpPr/>
              <p:nvPr/>
            </p:nvSpPr>
            <p:spPr>
              <a:xfrm flipH="1">
                <a:off x="2531160" y="387360"/>
                <a:ext cx="95760" cy="324000"/>
              </a:xfrm>
              <a:prstGeom prst="pi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Freeform 42"/>
              <p:cNvSpPr/>
              <p:nvPr/>
            </p:nvSpPr>
            <p:spPr>
              <a:xfrm flipH="1">
                <a:off x="2471040" y="387360"/>
                <a:ext cx="48960" cy="318960"/>
              </a:xfrm>
              <a:prstGeom prst="pie">
                <a:avLst/>
              </a:prstGeom>
              <a:blipFill rotWithShape="0">
                <a:blip r:embed="rId10"/>
                <a:srcRect/>
                <a:tile tx="0" ty="0" sx="100000" sy="100000" algn="ctr"/>
              </a:blipFill>
              <a:ln cap="rnd"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Freeform 43"/>
              <p:cNvSpPr/>
              <p:nvPr/>
            </p:nvSpPr>
            <p:spPr>
              <a:xfrm flipH="1">
                <a:off x="3145320" y="387360"/>
                <a:ext cx="196560" cy="324000"/>
              </a:xfrm>
              <a:prstGeom prst="pie">
                <a:avLst/>
              </a:prstGeom>
              <a:solidFill>
                <a:srgbClr val="808080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Freeform 44"/>
              <p:cNvSpPr/>
              <p:nvPr/>
            </p:nvSpPr>
            <p:spPr>
              <a:xfrm>
                <a:off x="4073400" y="387360"/>
                <a:ext cx="48960" cy="324000"/>
              </a:xfrm>
              <a:prstGeom prst="pie">
                <a:avLst/>
              </a:prstGeom>
              <a:solidFill>
                <a:srgbClr val="808080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Freeform 45"/>
              <p:cNvSpPr/>
              <p:nvPr/>
            </p:nvSpPr>
            <p:spPr>
              <a:xfrm flipH="1">
                <a:off x="4130640" y="387360"/>
                <a:ext cx="27360" cy="324000"/>
              </a:xfrm>
              <a:prstGeom prst="pie">
                <a:avLst/>
              </a:prstGeom>
              <a:solidFill>
                <a:srgbClr val="808080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Freeform 46"/>
              <p:cNvSpPr/>
              <p:nvPr/>
            </p:nvSpPr>
            <p:spPr>
              <a:xfrm flipH="1">
                <a:off x="4035240" y="387360"/>
                <a:ext cx="25920" cy="324000"/>
              </a:xfrm>
              <a:prstGeom prst="pie">
                <a:avLst/>
              </a:prstGeom>
              <a:solidFill>
                <a:srgbClr val="808080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" name="Freeform 47"/>
              <p:cNvSpPr/>
              <p:nvPr/>
            </p:nvSpPr>
            <p:spPr>
              <a:xfrm flipH="1">
                <a:off x="3829320" y="393480"/>
                <a:ext cx="198360" cy="322920"/>
              </a:xfrm>
              <a:prstGeom prst="pie">
                <a:avLst/>
              </a:prstGeom>
              <a:solidFill>
                <a:srgbClr val="808080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Rectangle 48"/>
              <p:cNvSpPr/>
              <p:nvPr/>
            </p:nvSpPr>
            <p:spPr>
              <a:xfrm>
                <a:off x="4174560" y="451080"/>
                <a:ext cx="27000" cy="18072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Rectangle 49"/>
              <p:cNvSpPr/>
              <p:nvPr/>
            </p:nvSpPr>
            <p:spPr>
              <a:xfrm>
                <a:off x="2414880" y="458280"/>
                <a:ext cx="39600" cy="16524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" name="Rectangle 50"/>
              <p:cNvSpPr/>
              <p:nvPr/>
            </p:nvSpPr>
            <p:spPr>
              <a:xfrm>
                <a:off x="2396160" y="458280"/>
                <a:ext cx="39240" cy="165240"/>
              </a:xfrm>
              <a:prstGeom prst="rect">
                <a:avLst/>
              </a:prstGeom>
              <a:solidFill>
                <a:srgbClr val="bbe0e3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" name="Line 52"/>
              <p:cNvSpPr/>
              <p:nvPr/>
            </p:nvSpPr>
            <p:spPr>
              <a:xfrm>
                <a:off x="2575080" y="578160"/>
                <a:ext cx="0" cy="147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" name="Text Box 53"/>
              <p:cNvSpPr/>
              <p:nvPr/>
            </p:nvSpPr>
            <p:spPr>
              <a:xfrm>
                <a:off x="4017240" y="194040"/>
                <a:ext cx="4003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DR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" name="Text Box 54"/>
              <p:cNvSpPr/>
              <p:nvPr/>
            </p:nvSpPr>
            <p:spPr>
              <a:xfrm>
                <a:off x="2579040" y="141120"/>
                <a:ext cx="4251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Int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Text Box 55"/>
              <p:cNvSpPr/>
              <p:nvPr/>
            </p:nvSpPr>
            <p:spPr>
              <a:xfrm>
                <a:off x="2240280" y="126720"/>
                <a:ext cx="4150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DR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Line 56"/>
              <p:cNvSpPr/>
              <p:nvPr/>
            </p:nvSpPr>
            <p:spPr>
              <a:xfrm>
                <a:off x="2423520" y="262440"/>
                <a:ext cx="18720" cy="188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Line 57"/>
              <p:cNvSpPr/>
              <p:nvPr/>
            </p:nvSpPr>
            <p:spPr>
              <a:xfrm flipH="1">
                <a:off x="2477880" y="302760"/>
                <a:ext cx="252720" cy="2131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Line 58"/>
              <p:cNvSpPr/>
              <p:nvPr/>
            </p:nvSpPr>
            <p:spPr>
              <a:xfrm flipH="1" flipV="1">
                <a:off x="2287800" y="390600"/>
                <a:ext cx="115920" cy="153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Text Box 59"/>
              <p:cNvSpPr/>
              <p:nvPr/>
            </p:nvSpPr>
            <p:spPr>
              <a:xfrm>
                <a:off x="1957320" y="267120"/>
                <a:ext cx="5522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tRNA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Line 60"/>
              <p:cNvSpPr/>
              <p:nvPr/>
            </p:nvSpPr>
            <p:spPr>
              <a:xfrm flipV="1">
                <a:off x="4189680" y="349200"/>
                <a:ext cx="15120" cy="188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Line 61"/>
              <p:cNvSpPr/>
              <p:nvPr/>
            </p:nvSpPr>
            <p:spPr>
              <a:xfrm flipV="1">
                <a:off x="2754360" y="569880"/>
                <a:ext cx="471240" cy="180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Line 62"/>
              <p:cNvSpPr/>
              <p:nvPr/>
            </p:nvSpPr>
            <p:spPr>
              <a:xfrm>
                <a:off x="2729520" y="304200"/>
                <a:ext cx="98280" cy="207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" name="Rectangle 67"/>
              <p:cNvSpPr/>
              <p:nvPr/>
            </p:nvSpPr>
            <p:spPr>
              <a:xfrm>
                <a:off x="3350520" y="470520"/>
                <a:ext cx="461880" cy="161280"/>
              </a:xfrm>
              <a:prstGeom prst="rect">
                <a:avLst/>
              </a:prstGeom>
              <a:solidFill>
                <a:srgbClr val="80808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Rectangle 69"/>
              <p:cNvSpPr/>
              <p:nvPr/>
            </p:nvSpPr>
            <p:spPr>
              <a:xfrm>
                <a:off x="2886840" y="470520"/>
                <a:ext cx="245520" cy="153000"/>
              </a:xfrm>
              <a:prstGeom prst="rect">
                <a:avLst/>
              </a:prstGeom>
              <a:solidFill>
                <a:srgbClr val="80808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Rectangle 68"/>
              <p:cNvSpPr/>
              <p:nvPr/>
            </p:nvSpPr>
            <p:spPr>
              <a:xfrm>
                <a:off x="2638080" y="470520"/>
                <a:ext cx="159840" cy="15300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40" name="Text Box 137"/>
            <p:cNvSpPr/>
            <p:nvPr/>
          </p:nvSpPr>
          <p:spPr>
            <a:xfrm>
              <a:off x="803160" y="3122640"/>
              <a:ext cx="688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VP3057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41" name="Picture 157" descr=""/>
            <p:cNvPicPr/>
            <p:nvPr/>
          </p:nvPicPr>
          <p:blipFill>
            <a:blip r:embed="rId11"/>
            <a:stretch/>
          </p:blipFill>
          <p:spPr>
            <a:xfrm>
              <a:off x="2306520" y="3240000"/>
              <a:ext cx="1103040" cy="185724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142" name="Group 200"/>
            <p:cNvGrpSpPr/>
            <p:nvPr/>
          </p:nvGrpSpPr>
          <p:grpSpPr>
            <a:xfrm>
              <a:off x="306000" y="4908240"/>
              <a:ext cx="1644840" cy="865080"/>
              <a:chOff x="306000" y="4908240"/>
              <a:chExt cx="1644840" cy="865080"/>
            </a:xfrm>
          </p:grpSpPr>
          <p:grpSp>
            <p:nvGrpSpPr>
              <p:cNvPr id="143" name="Group 153"/>
              <p:cNvGrpSpPr/>
              <p:nvPr/>
            </p:nvGrpSpPr>
            <p:grpSpPr>
              <a:xfrm>
                <a:off x="306000" y="5198400"/>
                <a:ext cx="1644840" cy="318960"/>
                <a:chOff x="306000" y="5198400"/>
                <a:chExt cx="1644840" cy="318960"/>
              </a:xfrm>
            </p:grpSpPr>
            <p:sp>
              <p:nvSpPr>
                <p:cNvPr id="144" name="Line 151"/>
                <p:cNvSpPr/>
                <p:nvPr/>
              </p:nvSpPr>
              <p:spPr>
                <a:xfrm flipV="1">
                  <a:off x="306000" y="5353560"/>
                  <a:ext cx="1644840" cy="2160"/>
                </a:xfrm>
                <a:prstGeom prst="line">
                  <a:avLst/>
                </a:prstGeom>
                <a:ln w="176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4640" bIns="-44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5" name="Rectangle 141"/>
                <p:cNvSpPr/>
                <p:nvPr/>
              </p:nvSpPr>
              <p:spPr>
                <a:xfrm>
                  <a:off x="775080" y="5287320"/>
                  <a:ext cx="405720" cy="142920"/>
                </a:xfrm>
                <a:prstGeom prst="rect">
                  <a:avLst/>
                </a:prstGeom>
                <a:solidFill>
                  <a:srgbClr val="fffff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6" name="AutoShape 142"/>
                <p:cNvSpPr/>
                <p:nvPr/>
              </p:nvSpPr>
              <p:spPr>
                <a:xfrm>
                  <a:off x="339840" y="5203080"/>
                  <a:ext cx="162720" cy="304200"/>
                </a:xfrm>
                <a:prstGeom prst="rightArrow">
                  <a:avLst>
                    <a:gd name="adj1" fmla="val 50000"/>
                    <a:gd name="adj2" fmla="val 25000"/>
                  </a:avLst>
                </a:prstGeom>
                <a:solidFill>
                  <a:srgbClr val="fffff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7" name="AutoShape 146"/>
                <p:cNvSpPr/>
                <p:nvPr/>
              </p:nvSpPr>
              <p:spPr>
                <a:xfrm>
                  <a:off x="520560" y="5203080"/>
                  <a:ext cx="74880" cy="304200"/>
                </a:xfrm>
                <a:prstGeom prst="rightArrow">
                  <a:avLst>
                    <a:gd name="adj1" fmla="val 50000"/>
                    <a:gd name="adj2" fmla="val 25000"/>
                  </a:avLst>
                </a:prstGeom>
                <a:blipFill rotWithShape="0">
                  <a:blip r:embed="rId12"/>
                  <a:srcRect/>
                  <a:tile tx="0" ty="0" sx="100000" sy="100000" algn="ctr"/>
                </a:blip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8" name="AutoShape 147"/>
                <p:cNvSpPr/>
                <p:nvPr/>
              </p:nvSpPr>
              <p:spPr>
                <a:xfrm>
                  <a:off x="695520" y="5212800"/>
                  <a:ext cx="69480" cy="304560"/>
                </a:xfrm>
                <a:prstGeom prst="rightArrow">
                  <a:avLst>
                    <a:gd name="adj1" fmla="val 50000"/>
                    <a:gd name="adj2" fmla="val 25000"/>
                  </a:avLst>
                </a:prstGeom>
                <a:blipFill rotWithShape="0">
                  <a:blip r:embed="rId13"/>
                  <a:srcRect/>
                  <a:tile tx="0" ty="0" sx="100000" sy="100000" algn="ctr"/>
                </a:blip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9" name="AutoShape 149"/>
                <p:cNvSpPr/>
                <p:nvPr/>
              </p:nvSpPr>
              <p:spPr>
                <a:xfrm flipH="1">
                  <a:off x="1320480" y="5198400"/>
                  <a:ext cx="109440" cy="304200"/>
                </a:xfrm>
                <a:prstGeom prst="rightArrow">
                  <a:avLst>
                    <a:gd name="adj1" fmla="val 50000"/>
                    <a:gd name="adj2" fmla="val 25000"/>
                  </a:avLst>
                </a:prstGeom>
                <a:solidFill>
                  <a:srgbClr val="fffff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0" name="AutoShape 150"/>
                <p:cNvSpPr/>
                <p:nvPr/>
              </p:nvSpPr>
              <p:spPr>
                <a:xfrm>
                  <a:off x="618840" y="5207760"/>
                  <a:ext cx="53280" cy="304200"/>
                </a:xfrm>
                <a:prstGeom prst="rightArrow">
                  <a:avLst>
                    <a:gd name="adj1" fmla="val 50000"/>
                    <a:gd name="adj2" fmla="val 25000"/>
                  </a:avLst>
                </a:prstGeom>
                <a:solidFill>
                  <a:srgbClr val="fffff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1" name="Rectangle 152"/>
                <p:cNvSpPr/>
                <p:nvPr/>
              </p:nvSpPr>
              <p:spPr>
                <a:xfrm>
                  <a:off x="1595520" y="5282640"/>
                  <a:ext cx="203400" cy="142920"/>
                </a:xfrm>
                <a:prstGeom prst="rect">
                  <a:avLst/>
                </a:prstGeom>
                <a:solidFill>
                  <a:srgbClr val="fffff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52" name="AutoShape 143"/>
              <p:cNvSpPr/>
              <p:nvPr/>
            </p:nvSpPr>
            <p:spPr>
              <a:xfrm rot="10800000">
                <a:off x="1458360" y="5195880"/>
                <a:ext cx="105120" cy="315360"/>
              </a:xfrm>
              <a:prstGeom prst="rightArrow">
                <a:avLst>
                  <a:gd name="adj1" fmla="val 50000"/>
                  <a:gd name="adj2" fmla="val 25000"/>
                </a:avLst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 rot="10800000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" name="AutoShape 148"/>
              <p:cNvSpPr/>
              <p:nvPr/>
            </p:nvSpPr>
            <p:spPr>
              <a:xfrm flipH="1">
                <a:off x="1211040" y="5203080"/>
                <a:ext cx="87120" cy="304200"/>
              </a:xfrm>
              <a:prstGeom prst="rightArrow">
                <a:avLst>
                  <a:gd name="adj1" fmla="val 50000"/>
                  <a:gd name="adj2" fmla="val 25000"/>
                </a:avLst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" name="Line 154"/>
              <p:cNvSpPr/>
              <p:nvPr/>
            </p:nvSpPr>
            <p:spPr>
              <a:xfrm flipV="1">
                <a:off x="320760" y="4917600"/>
                <a:ext cx="442800" cy="430200"/>
              </a:xfrm>
              <a:prstGeom prst="line">
                <a:avLst/>
              </a:prstGeom>
              <a:ln w="19080">
                <a:solidFill>
                  <a:srgbClr val="000000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" name="Line 155"/>
              <p:cNvSpPr/>
              <p:nvPr/>
            </p:nvSpPr>
            <p:spPr>
              <a:xfrm flipH="1" flipV="1">
                <a:off x="1069920" y="4908240"/>
                <a:ext cx="759960" cy="430200"/>
              </a:xfrm>
              <a:prstGeom prst="line">
                <a:avLst/>
              </a:prstGeom>
              <a:ln w="19080">
                <a:solidFill>
                  <a:srgbClr val="000000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" name="Text Box 161"/>
              <p:cNvSpPr/>
              <p:nvPr/>
            </p:nvSpPr>
            <p:spPr>
              <a:xfrm>
                <a:off x="495000" y="5496840"/>
                <a:ext cx="3499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</a:rPr>
                  <a:t>Int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" name="Line 162"/>
              <p:cNvSpPr/>
              <p:nvPr/>
            </p:nvSpPr>
            <p:spPr>
              <a:xfrm flipH="1" flipV="1">
                <a:off x="547560" y="5387400"/>
                <a:ext cx="90000" cy="168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" name="Line 163"/>
              <p:cNvSpPr/>
              <p:nvPr/>
            </p:nvSpPr>
            <p:spPr>
              <a:xfrm flipV="1">
                <a:off x="687240" y="5365440"/>
                <a:ext cx="32760" cy="18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" name="Text Box 164"/>
              <p:cNvSpPr/>
              <p:nvPr/>
            </p:nvSpPr>
            <p:spPr>
              <a:xfrm>
                <a:off x="887040" y="5489280"/>
                <a:ext cx="4870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</a:rPr>
                  <a:t>SMF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" name="Text Box 165"/>
              <p:cNvSpPr/>
              <p:nvPr/>
            </p:nvSpPr>
            <p:spPr>
              <a:xfrm>
                <a:off x="1413000" y="5496840"/>
                <a:ext cx="4856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</a:rPr>
                  <a:t>KAP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" name="Line 166"/>
              <p:cNvSpPr/>
              <p:nvPr/>
            </p:nvSpPr>
            <p:spPr>
              <a:xfrm flipV="1">
                <a:off x="1081080" y="5387400"/>
                <a:ext cx="163800" cy="168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" name="Line 167"/>
              <p:cNvSpPr/>
              <p:nvPr/>
            </p:nvSpPr>
            <p:spPr>
              <a:xfrm flipH="1" flipV="1">
                <a:off x="1499040" y="5358240"/>
                <a:ext cx="139320" cy="18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63" name="Group 201"/>
            <p:cNvGrpSpPr/>
            <p:nvPr/>
          </p:nvGrpSpPr>
          <p:grpSpPr>
            <a:xfrm>
              <a:off x="1822320" y="4885920"/>
              <a:ext cx="2203200" cy="865080"/>
              <a:chOff x="1822320" y="4885920"/>
              <a:chExt cx="2203200" cy="865080"/>
            </a:xfrm>
          </p:grpSpPr>
          <p:grpSp>
            <p:nvGrpSpPr>
              <p:cNvPr id="164" name="Group 182"/>
              <p:cNvGrpSpPr/>
              <p:nvPr/>
            </p:nvGrpSpPr>
            <p:grpSpPr>
              <a:xfrm>
                <a:off x="2059560" y="5193360"/>
                <a:ext cx="1644840" cy="304560"/>
                <a:chOff x="2059560" y="5193360"/>
                <a:chExt cx="1644840" cy="304560"/>
              </a:xfrm>
            </p:grpSpPr>
            <p:sp>
              <p:nvSpPr>
                <p:cNvPr id="165" name="Line 169"/>
                <p:cNvSpPr/>
                <p:nvPr/>
              </p:nvSpPr>
              <p:spPr>
                <a:xfrm flipV="1">
                  <a:off x="2059560" y="5333760"/>
                  <a:ext cx="1644840" cy="2160"/>
                </a:xfrm>
                <a:prstGeom prst="line">
                  <a:avLst/>
                </a:prstGeom>
                <a:ln w="176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4640" bIns="-44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6" name="Rectangle 170"/>
                <p:cNvSpPr/>
                <p:nvPr/>
              </p:nvSpPr>
              <p:spPr>
                <a:xfrm>
                  <a:off x="3233880" y="5274000"/>
                  <a:ext cx="405720" cy="142920"/>
                </a:xfrm>
                <a:prstGeom prst="rect">
                  <a:avLst/>
                </a:prstGeom>
                <a:solidFill>
                  <a:srgbClr val="fffff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7" name="AutoShape 171"/>
                <p:cNvSpPr/>
                <p:nvPr/>
              </p:nvSpPr>
              <p:spPr>
                <a:xfrm>
                  <a:off x="2126520" y="5193360"/>
                  <a:ext cx="162720" cy="304560"/>
                </a:xfrm>
                <a:prstGeom prst="rightArrow">
                  <a:avLst>
                    <a:gd name="adj1" fmla="val 50000"/>
                    <a:gd name="adj2" fmla="val 25000"/>
                  </a:avLst>
                </a:prstGeom>
                <a:blipFill rotWithShape="0">
                  <a:blip r:embed="rId14"/>
                  <a:srcRect/>
                  <a:tile tx="0" ty="0" sx="100000" sy="100000" algn="ctr"/>
                </a:blip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8" name="AutoShape 172"/>
                <p:cNvSpPr/>
                <p:nvPr/>
              </p:nvSpPr>
              <p:spPr>
                <a:xfrm flipH="1">
                  <a:off x="2306160" y="5193360"/>
                  <a:ext cx="75240" cy="304560"/>
                </a:xfrm>
                <a:prstGeom prst="rightArrow">
                  <a:avLst>
                    <a:gd name="adj1" fmla="val 50000"/>
                    <a:gd name="adj2" fmla="val 25000"/>
                  </a:avLst>
                </a:prstGeom>
                <a:solidFill>
                  <a:srgbClr val="fffff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9" name="AutoShape 173"/>
                <p:cNvSpPr/>
                <p:nvPr/>
              </p:nvSpPr>
              <p:spPr>
                <a:xfrm>
                  <a:off x="2539440" y="5193360"/>
                  <a:ext cx="36720" cy="304560"/>
                </a:xfrm>
                <a:prstGeom prst="rightArrow">
                  <a:avLst>
                    <a:gd name="adj1" fmla="val 50000"/>
                    <a:gd name="adj2" fmla="val 25000"/>
                  </a:avLst>
                </a:prstGeom>
                <a:solidFill>
                  <a:srgbClr val="fffff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0" name="AutoShape 175"/>
                <p:cNvSpPr/>
                <p:nvPr/>
              </p:nvSpPr>
              <p:spPr>
                <a:xfrm>
                  <a:off x="2405520" y="5193360"/>
                  <a:ext cx="118440" cy="304560"/>
                </a:xfrm>
                <a:prstGeom prst="rightArrow">
                  <a:avLst>
                    <a:gd name="adj1" fmla="val 50000"/>
                    <a:gd name="adj2" fmla="val 25000"/>
                  </a:avLst>
                </a:prstGeom>
                <a:solidFill>
                  <a:srgbClr val="fffff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1" name="AutoShape 177"/>
                <p:cNvSpPr/>
                <p:nvPr/>
              </p:nvSpPr>
              <p:spPr>
                <a:xfrm>
                  <a:off x="2588400" y="5193360"/>
                  <a:ext cx="36720" cy="304560"/>
                </a:xfrm>
                <a:prstGeom prst="rightArrow">
                  <a:avLst>
                    <a:gd name="adj1" fmla="val 50000"/>
                    <a:gd name="adj2" fmla="val 25000"/>
                  </a:avLst>
                </a:prstGeom>
                <a:solidFill>
                  <a:srgbClr val="fffff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2" name="AutoShape 178"/>
                <p:cNvSpPr/>
                <p:nvPr/>
              </p:nvSpPr>
              <p:spPr>
                <a:xfrm>
                  <a:off x="2651400" y="5193360"/>
                  <a:ext cx="118800" cy="304560"/>
                </a:xfrm>
                <a:prstGeom prst="rightArrow">
                  <a:avLst>
                    <a:gd name="adj1" fmla="val 50000"/>
                    <a:gd name="adj2" fmla="val 25000"/>
                  </a:avLst>
                </a:prstGeom>
                <a:solidFill>
                  <a:srgbClr val="fffff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3" name="AutoShape 179"/>
                <p:cNvSpPr/>
                <p:nvPr/>
              </p:nvSpPr>
              <p:spPr>
                <a:xfrm>
                  <a:off x="2790720" y="5193360"/>
                  <a:ext cx="118800" cy="304560"/>
                </a:xfrm>
                <a:prstGeom prst="rightArrow">
                  <a:avLst>
                    <a:gd name="adj1" fmla="val 50000"/>
                    <a:gd name="adj2" fmla="val 25000"/>
                  </a:avLst>
                </a:prstGeom>
                <a:solidFill>
                  <a:srgbClr val="fffff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4" name="AutoShape 180"/>
                <p:cNvSpPr/>
                <p:nvPr/>
              </p:nvSpPr>
              <p:spPr>
                <a:xfrm>
                  <a:off x="2913840" y="5193360"/>
                  <a:ext cx="118800" cy="304560"/>
                </a:xfrm>
                <a:prstGeom prst="rightArrow">
                  <a:avLst>
                    <a:gd name="adj1" fmla="val 50000"/>
                    <a:gd name="adj2" fmla="val 25000"/>
                  </a:avLst>
                </a:prstGeom>
                <a:solidFill>
                  <a:srgbClr val="fffff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5" name="AutoShape 181"/>
                <p:cNvSpPr/>
                <p:nvPr/>
              </p:nvSpPr>
              <p:spPr>
                <a:xfrm>
                  <a:off x="3078000" y="5193360"/>
                  <a:ext cx="118800" cy="304560"/>
                </a:xfrm>
                <a:prstGeom prst="rightArrow">
                  <a:avLst>
                    <a:gd name="adj1" fmla="val 50000"/>
                    <a:gd name="adj2" fmla="val 25000"/>
                  </a:avLst>
                </a:prstGeom>
                <a:solidFill>
                  <a:srgbClr val="fffff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76" name="Text Box 183"/>
              <p:cNvSpPr/>
              <p:nvPr/>
            </p:nvSpPr>
            <p:spPr>
              <a:xfrm>
                <a:off x="1822320" y="5474520"/>
                <a:ext cx="22032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</a:rPr>
                  <a:t>Int    Xis Helicase HsdR  HsdMS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" name="Line 184"/>
              <p:cNvSpPr/>
              <p:nvPr/>
            </p:nvSpPr>
            <p:spPr>
              <a:xfrm flipV="1">
                <a:off x="1990080" y="5372640"/>
                <a:ext cx="180360" cy="146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" name="Line 185"/>
              <p:cNvSpPr/>
              <p:nvPr/>
            </p:nvSpPr>
            <p:spPr>
              <a:xfrm flipV="1">
                <a:off x="2269080" y="5343120"/>
                <a:ext cx="73440" cy="2055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" name="Line 186"/>
              <p:cNvSpPr/>
              <p:nvPr/>
            </p:nvSpPr>
            <p:spPr>
              <a:xfrm flipH="1" flipV="1">
                <a:off x="2432880" y="5357880"/>
                <a:ext cx="139320" cy="2055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" name="Line 187"/>
              <p:cNvSpPr/>
              <p:nvPr/>
            </p:nvSpPr>
            <p:spPr>
              <a:xfrm flipH="1" flipV="1">
                <a:off x="2670840" y="5358240"/>
                <a:ext cx="319680" cy="190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" name="Line 188"/>
              <p:cNvSpPr/>
              <p:nvPr/>
            </p:nvSpPr>
            <p:spPr>
              <a:xfrm flipH="1" flipV="1">
                <a:off x="2941200" y="5373000"/>
                <a:ext cx="508680" cy="161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" name="Line 189"/>
              <p:cNvSpPr/>
              <p:nvPr/>
            </p:nvSpPr>
            <p:spPr>
              <a:xfrm flipH="1" flipV="1">
                <a:off x="3146760" y="5343120"/>
                <a:ext cx="401760" cy="168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" name="Line 190"/>
              <p:cNvSpPr/>
              <p:nvPr/>
            </p:nvSpPr>
            <p:spPr>
              <a:xfrm flipV="1">
                <a:off x="2090880" y="4888440"/>
                <a:ext cx="442800" cy="430560"/>
              </a:xfrm>
              <a:prstGeom prst="line">
                <a:avLst/>
              </a:prstGeom>
              <a:ln w="19080">
                <a:solidFill>
                  <a:srgbClr val="000000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" name="Line 191"/>
              <p:cNvSpPr/>
              <p:nvPr/>
            </p:nvSpPr>
            <p:spPr>
              <a:xfrm flipH="1" flipV="1">
                <a:off x="3324600" y="4885920"/>
                <a:ext cx="357840" cy="459720"/>
              </a:xfrm>
              <a:prstGeom prst="line">
                <a:avLst/>
              </a:prstGeom>
              <a:ln w="19080">
                <a:solidFill>
                  <a:srgbClr val="000000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85" name="Text Box 192"/>
            <p:cNvSpPr/>
            <p:nvPr/>
          </p:nvSpPr>
          <p:spPr>
            <a:xfrm>
              <a:off x="-55800" y="691920"/>
              <a:ext cx="833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LysR Omp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Line 193"/>
            <p:cNvSpPr/>
            <p:nvPr/>
          </p:nvSpPr>
          <p:spPr>
            <a:xfrm flipV="1">
              <a:off x="374400" y="620640"/>
              <a:ext cx="98280" cy="263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Line 194"/>
            <p:cNvSpPr/>
            <p:nvPr/>
          </p:nvSpPr>
          <p:spPr>
            <a:xfrm flipH="1" flipV="1">
              <a:off x="563040" y="620640"/>
              <a:ext cx="90360" cy="27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Text Box 195"/>
            <p:cNvSpPr/>
            <p:nvPr/>
          </p:nvSpPr>
          <p:spPr>
            <a:xfrm>
              <a:off x="37440" y="142920"/>
              <a:ext cx="104796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Nitrilase/cyanid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hydratas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Line 196"/>
            <p:cNvSpPr/>
            <p:nvPr/>
          </p:nvSpPr>
          <p:spPr>
            <a:xfrm flipH="1" flipV="1">
              <a:off x="252000" y="503280"/>
              <a:ext cx="90720" cy="123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Text Box 198"/>
            <p:cNvSpPr/>
            <p:nvPr/>
          </p:nvSpPr>
          <p:spPr>
            <a:xfrm>
              <a:off x="75960" y="-17280"/>
              <a:ext cx="328680" cy="3379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A.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B.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"/>
            <p:cNvSpPr/>
            <p:nvPr/>
          </p:nvSpPr>
          <p:spPr>
            <a:xfrm>
              <a:off x="1856880" y="799920"/>
              <a:ext cx="71424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84080"/>
                  <a:tab algn="l" pos="1568520"/>
                  <a:tab algn="l" pos="2352600"/>
                  <a:tab algn="l" pos="3137040"/>
                  <a:tab algn="l" pos="3921120"/>
                  <a:tab algn="l" pos="4705200"/>
                  <a:tab algn="l" pos="5489640"/>
                  <a:tab algn="l" pos="6273720"/>
                  <a:tab algn="l" pos="7058160"/>
                  <a:tab algn="l" pos="7842240"/>
                  <a:tab algn="l" pos="8626320"/>
                  <a:tab algn="l" pos="9410760"/>
                  <a:tab algn="l" pos="1019484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RIM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784080"/>
                  <a:tab algn="l" pos="1568520"/>
                  <a:tab algn="l" pos="2352600"/>
                  <a:tab algn="l" pos="3137040"/>
                  <a:tab algn="l" pos="3921120"/>
                  <a:tab algn="l" pos="4705200"/>
                  <a:tab algn="l" pos="5489640"/>
                  <a:tab algn="l" pos="6273720"/>
                  <a:tab algn="l" pos="7058160"/>
                  <a:tab algn="l" pos="7842240"/>
                  <a:tab algn="l" pos="8626320"/>
                  <a:tab algn="l" pos="9410760"/>
                  <a:tab algn="l" pos="1019484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221063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"/>
            <p:cNvSpPr/>
            <p:nvPr/>
          </p:nvSpPr>
          <p:spPr>
            <a:xfrm>
              <a:off x="1820520" y="2341440"/>
              <a:ext cx="714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784080"/>
                  <a:tab algn="l" pos="1568520"/>
                  <a:tab algn="l" pos="2352600"/>
                  <a:tab algn="l" pos="3137040"/>
                  <a:tab algn="l" pos="3921120"/>
                  <a:tab algn="l" pos="4705200"/>
                  <a:tab algn="l" pos="5489640"/>
                  <a:tab algn="l" pos="6273720"/>
                  <a:tab algn="l" pos="7058160"/>
                  <a:tab algn="l" pos="7842240"/>
                  <a:tab algn="l" pos="8626320"/>
                  <a:tab algn="l" pos="9410760"/>
                  <a:tab algn="l" pos="1019484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AQ381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5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8-21T14:06:44Z</dcterms:created>
  <dc:creator>E. Fidelma Boyd</dc:creator>
  <dc:description/>
  <dc:language>en-US</dc:language>
  <cp:lastModifiedBy>E. Fidelma Boyd</cp:lastModifiedBy>
  <dcterms:modified xsi:type="dcterms:W3CDTF">2008-06-27T18:57:59Z</dcterms:modified>
  <cp:revision>51</cp:revision>
  <dc:subject/>
  <dc:title>Slide 1</dc:title>
</cp:coreProperties>
</file>